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theme/themeOverride1.xml" ContentType="application/vnd.openxmlformats-officedocument.themeOverride+xml"/>
  <Override PartName="/ppt/notesSlides/notesSlide3.xml" ContentType="application/vnd.openxmlformats-officedocument.presentationml.notesSlide+xml"/>
  <Override PartName="/ppt/theme/themeOverride2.xml" ContentType="application/vnd.openxmlformats-officedocument.themeOverride+xml"/>
  <Override PartName="/ppt/notesSlides/notesSlide4.xml" ContentType="application/vnd.openxmlformats-officedocument.presentationml.notesSlide+xml"/>
  <Override PartName="/ppt/theme/themeOverride3.xml" ContentType="application/vnd.openxmlformats-officedocument.themeOverr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4" r:id="rId1"/>
  </p:sldMasterIdLst>
  <p:notesMasterIdLst>
    <p:notesMasterId r:id="rId7"/>
  </p:notesMasterIdLst>
  <p:sldIdLst>
    <p:sldId id="256" r:id="rId2"/>
    <p:sldId id="271" r:id="rId3"/>
    <p:sldId id="272" r:id="rId4"/>
    <p:sldId id="264" r:id="rId5"/>
    <p:sldId id="269" r:id="rId6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C32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1C704AE-D5E0-4E68-AD40-1EC0A2669F77}" v="45" dt="2024-07-21T20:53:49.96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58" autoAdjust="0"/>
    <p:restoredTop sz="94626" autoAdjust="0"/>
  </p:normalViewPr>
  <p:slideViewPr>
    <p:cSldViewPr snapToGrid="0" snapToObjects="1">
      <p:cViewPr varScale="1">
        <p:scale>
          <a:sx n="65" d="100"/>
          <a:sy n="65" d="100"/>
        </p:scale>
        <p:origin x="26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-Odat, Omar Sami Faleh" userId="00ed9233-b732-4002-afb5-4e27259fd0a0" providerId="ADAL" clId="{F393D814-7CDA-4B7C-AEBF-D850F038BB7F}"/>
    <pc:docChg chg="undo custSel modSld">
      <pc:chgData name="Al-Odat, Omar Sami Faleh" userId="00ed9233-b732-4002-afb5-4e27259fd0a0" providerId="ADAL" clId="{F393D814-7CDA-4B7C-AEBF-D850F038BB7F}" dt="2024-01-08T00:56:02.296" v="161" actId="1035"/>
      <pc:docMkLst>
        <pc:docMk/>
      </pc:docMkLst>
      <pc:sldChg chg="addSp delSp modSp mod">
        <pc:chgData name="Al-Odat, Omar Sami Faleh" userId="00ed9233-b732-4002-afb5-4e27259fd0a0" providerId="ADAL" clId="{F393D814-7CDA-4B7C-AEBF-D850F038BB7F}" dt="2024-01-07T23:49:24.467" v="23" actId="1076"/>
        <pc:sldMkLst>
          <pc:docMk/>
          <pc:sldMk cId="2573125304" sldId="256"/>
        </pc:sldMkLst>
        <pc:graphicFrameChg chg="del mod">
          <ac:chgData name="Al-Odat, Omar Sami Faleh" userId="00ed9233-b732-4002-afb5-4e27259fd0a0" providerId="ADAL" clId="{F393D814-7CDA-4B7C-AEBF-D850F038BB7F}" dt="2024-01-07T23:48:01.165" v="12" actId="478"/>
          <ac:graphicFrameMkLst>
            <pc:docMk/>
            <pc:sldMk cId="2573125304" sldId="256"/>
            <ac:graphicFrameMk id="6" creationId="{83EFDECB-F14B-9C14-4FCC-09C57042E02A}"/>
          </ac:graphicFrameMkLst>
        </pc:graphicFrameChg>
        <pc:graphicFrameChg chg="add mod">
          <ac:chgData name="Al-Odat, Omar Sami Faleh" userId="00ed9233-b732-4002-afb5-4e27259fd0a0" providerId="ADAL" clId="{F393D814-7CDA-4B7C-AEBF-D850F038BB7F}" dt="2024-01-07T23:47:58.439" v="11" actId="1076"/>
          <ac:graphicFrameMkLst>
            <pc:docMk/>
            <pc:sldMk cId="2573125304" sldId="256"/>
            <ac:graphicFrameMk id="7" creationId="{9DD1641A-C8DD-6FFC-BA29-20F395B181C8}"/>
          </ac:graphicFrameMkLst>
        </pc:graphicFrameChg>
        <pc:graphicFrameChg chg="add mod">
          <ac:chgData name="Al-Odat, Omar Sami Faleh" userId="00ed9233-b732-4002-afb5-4e27259fd0a0" providerId="ADAL" clId="{F393D814-7CDA-4B7C-AEBF-D850F038BB7F}" dt="2024-01-07T23:49:24.467" v="23" actId="1076"/>
          <ac:graphicFrameMkLst>
            <pc:docMk/>
            <pc:sldMk cId="2573125304" sldId="256"/>
            <ac:graphicFrameMk id="8" creationId="{1501DEF2-CD84-6C21-C031-E1E0343AB50E}"/>
          </ac:graphicFrameMkLst>
        </pc:graphicFrameChg>
        <pc:graphicFrameChg chg="del mod">
          <ac:chgData name="Al-Odat, Omar Sami Faleh" userId="00ed9233-b732-4002-afb5-4e27259fd0a0" providerId="ADAL" clId="{F393D814-7CDA-4B7C-AEBF-D850F038BB7F}" dt="2024-01-07T23:49:20.929" v="22" actId="478"/>
          <ac:graphicFrameMkLst>
            <pc:docMk/>
            <pc:sldMk cId="2573125304" sldId="256"/>
            <ac:graphicFrameMk id="10" creationId="{4339523A-1706-FD06-397E-2DDF52AF802B}"/>
          </ac:graphicFrameMkLst>
        </pc:graphicFrameChg>
      </pc:sldChg>
      <pc:sldChg chg="addSp delSp modSp mod">
        <pc:chgData name="Al-Odat, Omar Sami Faleh" userId="00ed9233-b732-4002-afb5-4e27259fd0a0" providerId="ADAL" clId="{F393D814-7CDA-4B7C-AEBF-D850F038BB7F}" dt="2024-01-08T00:33:31.519" v="92" actId="1037"/>
        <pc:sldMkLst>
          <pc:docMk/>
          <pc:sldMk cId="2971561120" sldId="264"/>
        </pc:sldMkLst>
        <pc:spChg chg="mod">
          <ac:chgData name="Al-Odat, Omar Sami Faleh" userId="00ed9233-b732-4002-afb5-4e27259fd0a0" providerId="ADAL" clId="{F393D814-7CDA-4B7C-AEBF-D850F038BB7F}" dt="2024-01-08T00:29:20.223" v="75" actId="1076"/>
          <ac:spMkLst>
            <pc:docMk/>
            <pc:sldMk cId="2971561120" sldId="264"/>
            <ac:spMk id="9" creationId="{E5AA7A2D-0EAE-96C5-5B7A-D6D5604EDF46}"/>
          </ac:spMkLst>
        </pc:spChg>
        <pc:spChg chg="mod">
          <ac:chgData name="Al-Odat, Omar Sami Faleh" userId="00ed9233-b732-4002-afb5-4e27259fd0a0" providerId="ADAL" clId="{F393D814-7CDA-4B7C-AEBF-D850F038BB7F}" dt="2024-01-08T00:29:17.435" v="74" actId="1076"/>
          <ac:spMkLst>
            <pc:docMk/>
            <pc:sldMk cId="2971561120" sldId="264"/>
            <ac:spMk id="11" creationId="{1EB4ACAB-B60C-AE77-3F2C-14C13D1CE370}"/>
          </ac:spMkLst>
        </pc:spChg>
        <pc:spChg chg="mod">
          <ac:chgData name="Al-Odat, Omar Sami Faleh" userId="00ed9233-b732-4002-afb5-4e27259fd0a0" providerId="ADAL" clId="{F393D814-7CDA-4B7C-AEBF-D850F038BB7F}" dt="2024-01-08T00:29:24.094" v="76" actId="1076"/>
          <ac:spMkLst>
            <pc:docMk/>
            <pc:sldMk cId="2971561120" sldId="264"/>
            <ac:spMk id="22" creationId="{D36BB31D-2D26-F507-652B-9D039966D581}"/>
          </ac:spMkLst>
        </pc:spChg>
        <pc:spChg chg="mod">
          <ac:chgData name="Al-Odat, Omar Sami Faleh" userId="00ed9233-b732-4002-afb5-4e27259fd0a0" providerId="ADAL" clId="{F393D814-7CDA-4B7C-AEBF-D850F038BB7F}" dt="2024-01-08T00:26:43.666" v="60" actId="1076"/>
          <ac:spMkLst>
            <pc:docMk/>
            <pc:sldMk cId="2971561120" sldId="264"/>
            <ac:spMk id="28" creationId="{8CF43914-9E55-A249-B114-0DCB10BC61E6}"/>
          </ac:spMkLst>
        </pc:spChg>
        <pc:spChg chg="mod">
          <ac:chgData name="Al-Odat, Omar Sami Faleh" userId="00ed9233-b732-4002-afb5-4e27259fd0a0" providerId="ADAL" clId="{F393D814-7CDA-4B7C-AEBF-D850F038BB7F}" dt="2024-01-08T00:26:40.286" v="59" actId="1076"/>
          <ac:spMkLst>
            <pc:docMk/>
            <pc:sldMk cId="2971561120" sldId="264"/>
            <ac:spMk id="118" creationId="{28E4AB3B-1983-5A11-AF9B-BE6F3A5CCF08}"/>
          </ac:spMkLst>
        </pc:spChg>
        <pc:graphicFrameChg chg="del mod">
          <ac:chgData name="Al-Odat, Omar Sami Faleh" userId="00ed9233-b732-4002-afb5-4e27259fd0a0" providerId="ADAL" clId="{F393D814-7CDA-4B7C-AEBF-D850F038BB7F}" dt="2024-01-08T00:29:00.685" v="69" actId="478"/>
          <ac:graphicFrameMkLst>
            <pc:docMk/>
            <pc:sldMk cId="2971561120" sldId="264"/>
            <ac:graphicFrameMk id="3" creationId="{3F4B4A02-D749-B427-93A9-CD2C41423054}"/>
          </ac:graphicFrameMkLst>
        </pc:graphicFrameChg>
        <pc:graphicFrameChg chg="del mod">
          <ac:chgData name="Al-Odat, Omar Sami Faleh" userId="00ed9233-b732-4002-afb5-4e27259fd0a0" providerId="ADAL" clId="{F393D814-7CDA-4B7C-AEBF-D850F038BB7F}" dt="2024-01-08T00:33:25.369" v="91" actId="478"/>
          <ac:graphicFrameMkLst>
            <pc:docMk/>
            <pc:sldMk cId="2971561120" sldId="264"/>
            <ac:graphicFrameMk id="4" creationId="{F60E9C1D-02A3-8635-4D46-8972FFDFD342}"/>
          </ac:graphicFrameMkLst>
        </pc:graphicFrameChg>
        <pc:graphicFrameChg chg="add mod">
          <ac:chgData name="Al-Odat, Omar Sami Faleh" userId="00ed9233-b732-4002-afb5-4e27259fd0a0" providerId="ADAL" clId="{F393D814-7CDA-4B7C-AEBF-D850F038BB7F}" dt="2024-01-08T00:26:27.443" v="55" actId="1076"/>
          <ac:graphicFrameMkLst>
            <pc:docMk/>
            <pc:sldMk cId="2971561120" sldId="264"/>
            <ac:graphicFrameMk id="25" creationId="{5B41EB5B-3D5B-406A-7561-86E514C48F29}"/>
          </ac:graphicFrameMkLst>
        </pc:graphicFrameChg>
        <pc:graphicFrameChg chg="add mod">
          <ac:chgData name="Al-Odat, Omar Sami Faleh" userId="00ed9233-b732-4002-afb5-4e27259fd0a0" providerId="ADAL" clId="{F393D814-7CDA-4B7C-AEBF-D850F038BB7F}" dt="2024-01-08T00:26:31.065" v="56" actId="1076"/>
          <ac:graphicFrameMkLst>
            <pc:docMk/>
            <pc:sldMk cId="2971561120" sldId="264"/>
            <ac:graphicFrameMk id="26" creationId="{C4E0B28B-3808-FAE4-B9E5-6586138E6ACA}"/>
          </ac:graphicFrameMkLst>
        </pc:graphicFrameChg>
        <pc:graphicFrameChg chg="add mod">
          <ac:chgData name="Al-Odat, Omar Sami Faleh" userId="00ed9233-b732-4002-afb5-4e27259fd0a0" providerId="ADAL" clId="{F393D814-7CDA-4B7C-AEBF-D850F038BB7F}" dt="2024-01-08T00:32:51.753" v="87" actId="1076"/>
          <ac:graphicFrameMkLst>
            <pc:docMk/>
            <pc:sldMk cId="2971561120" sldId="264"/>
            <ac:graphicFrameMk id="27" creationId="{A488B49F-94B4-263F-88EE-22F5349171D1}"/>
          </ac:graphicFrameMkLst>
        </pc:graphicFrameChg>
        <pc:graphicFrameChg chg="add mod">
          <ac:chgData name="Al-Odat, Omar Sami Faleh" userId="00ed9233-b732-4002-afb5-4e27259fd0a0" providerId="ADAL" clId="{F393D814-7CDA-4B7C-AEBF-D850F038BB7F}" dt="2024-01-08T00:33:31.519" v="92" actId="1037"/>
          <ac:graphicFrameMkLst>
            <pc:docMk/>
            <pc:sldMk cId="2971561120" sldId="264"/>
            <ac:graphicFrameMk id="29" creationId="{68F26A1C-CD29-5043-19D0-3E9026BF5341}"/>
          </ac:graphicFrameMkLst>
        </pc:graphicFrameChg>
        <pc:graphicFrameChg chg="del mod">
          <ac:chgData name="Al-Odat, Omar Sami Faleh" userId="00ed9233-b732-4002-afb5-4e27259fd0a0" providerId="ADAL" clId="{F393D814-7CDA-4B7C-AEBF-D850F038BB7F}" dt="2024-01-08T00:26:19.706" v="53" actId="478"/>
          <ac:graphicFrameMkLst>
            <pc:docMk/>
            <pc:sldMk cId="2971561120" sldId="264"/>
            <ac:graphicFrameMk id="122" creationId="{4F22883D-6290-9197-525C-40009B0D7CDB}"/>
          </ac:graphicFrameMkLst>
        </pc:graphicFrameChg>
        <pc:graphicFrameChg chg="del mod">
          <ac:chgData name="Al-Odat, Omar Sami Faleh" userId="00ed9233-b732-4002-afb5-4e27259fd0a0" providerId="ADAL" clId="{F393D814-7CDA-4B7C-AEBF-D850F038BB7F}" dt="2024-01-08T00:24:38.576" v="43" actId="478"/>
          <ac:graphicFrameMkLst>
            <pc:docMk/>
            <pc:sldMk cId="2971561120" sldId="264"/>
            <ac:graphicFrameMk id="142" creationId="{EEA22F05-9BCA-92C8-957F-06CD1F603BD1}"/>
          </ac:graphicFrameMkLst>
        </pc:graphicFrameChg>
        <pc:picChg chg="mod">
          <ac:chgData name="Al-Odat, Omar Sami Faleh" userId="00ed9233-b732-4002-afb5-4e27259fd0a0" providerId="ADAL" clId="{F393D814-7CDA-4B7C-AEBF-D850F038BB7F}" dt="2024-01-08T00:26:46.630" v="61" actId="1076"/>
          <ac:picMkLst>
            <pc:docMk/>
            <pc:sldMk cId="2971561120" sldId="264"/>
            <ac:picMk id="6" creationId="{599D8FAB-A9D1-15CE-4DDA-B782FA75AD46}"/>
          </ac:picMkLst>
        </pc:picChg>
        <pc:picChg chg="mod">
          <ac:chgData name="Al-Odat, Omar Sami Faleh" userId="00ed9233-b732-4002-afb5-4e27259fd0a0" providerId="ADAL" clId="{F393D814-7CDA-4B7C-AEBF-D850F038BB7F}" dt="2024-01-08T00:26:34.333" v="57" actId="1076"/>
          <ac:picMkLst>
            <pc:docMk/>
            <pc:sldMk cId="2971561120" sldId="264"/>
            <ac:picMk id="7" creationId="{3F58AEF9-DB0D-E7F5-EFDF-D9786E221096}"/>
          </ac:picMkLst>
        </pc:picChg>
        <pc:picChg chg="mod">
          <ac:chgData name="Al-Odat, Omar Sami Faleh" userId="00ed9233-b732-4002-afb5-4e27259fd0a0" providerId="ADAL" clId="{F393D814-7CDA-4B7C-AEBF-D850F038BB7F}" dt="2024-01-08T00:26:36.648" v="58" actId="1076"/>
          <ac:picMkLst>
            <pc:docMk/>
            <pc:sldMk cId="2971561120" sldId="264"/>
            <ac:picMk id="16" creationId="{4083B46A-CE54-E55D-30D5-AB6FD1896CD6}"/>
          </ac:picMkLst>
        </pc:picChg>
        <pc:picChg chg="mod">
          <ac:chgData name="Al-Odat, Omar Sami Faleh" userId="00ed9233-b732-4002-afb5-4e27259fd0a0" providerId="ADAL" clId="{F393D814-7CDA-4B7C-AEBF-D850F038BB7F}" dt="2024-01-08T00:29:13.560" v="73" actId="1076"/>
          <ac:picMkLst>
            <pc:docMk/>
            <pc:sldMk cId="2971561120" sldId="264"/>
            <ac:picMk id="23" creationId="{DF4A4556-65FF-CB2F-7740-F5F717779D78}"/>
          </ac:picMkLst>
        </pc:picChg>
        <pc:picChg chg="mod">
          <ac:chgData name="Al-Odat, Omar Sami Faleh" userId="00ed9233-b732-4002-afb5-4e27259fd0a0" providerId="ADAL" clId="{F393D814-7CDA-4B7C-AEBF-D850F038BB7F}" dt="2024-01-08T00:29:09.048" v="71" actId="1076"/>
          <ac:picMkLst>
            <pc:docMk/>
            <pc:sldMk cId="2971561120" sldId="264"/>
            <ac:picMk id="24" creationId="{6AAC207B-DD94-5A23-66C4-CC9F48311D19}"/>
          </ac:picMkLst>
        </pc:picChg>
      </pc:sldChg>
      <pc:sldChg chg="addSp delSp modSp mod">
        <pc:chgData name="Al-Odat, Omar Sami Faleh" userId="00ed9233-b732-4002-afb5-4e27259fd0a0" providerId="ADAL" clId="{F393D814-7CDA-4B7C-AEBF-D850F038BB7F}" dt="2024-01-08T00:56:02.296" v="161" actId="1035"/>
        <pc:sldMkLst>
          <pc:docMk/>
          <pc:sldMk cId="539791449" sldId="269"/>
        </pc:sldMkLst>
        <pc:spChg chg="mod">
          <ac:chgData name="Al-Odat, Omar Sami Faleh" userId="00ed9233-b732-4002-afb5-4e27259fd0a0" providerId="ADAL" clId="{F393D814-7CDA-4B7C-AEBF-D850F038BB7F}" dt="2024-01-08T00:55:55.769" v="136" actId="1036"/>
          <ac:spMkLst>
            <pc:docMk/>
            <pc:sldMk cId="539791449" sldId="269"/>
            <ac:spMk id="3" creationId="{9F117B5D-D2DB-3B73-9809-16FC2BBD8DD6}"/>
          </ac:spMkLst>
        </pc:spChg>
        <pc:spChg chg="mod">
          <ac:chgData name="Al-Odat, Omar Sami Faleh" userId="00ed9233-b732-4002-afb5-4e27259fd0a0" providerId="ADAL" clId="{F393D814-7CDA-4B7C-AEBF-D850F038BB7F}" dt="2024-01-08T00:55:55.769" v="136" actId="1036"/>
          <ac:spMkLst>
            <pc:docMk/>
            <pc:sldMk cId="539791449" sldId="269"/>
            <ac:spMk id="5" creationId="{C0BB567E-4C47-BA17-9576-1C0ACEA5C6B8}"/>
          </ac:spMkLst>
        </pc:spChg>
        <pc:spChg chg="mod">
          <ac:chgData name="Al-Odat, Omar Sami Faleh" userId="00ed9233-b732-4002-afb5-4e27259fd0a0" providerId="ADAL" clId="{F393D814-7CDA-4B7C-AEBF-D850F038BB7F}" dt="2024-01-08T00:55:55.769" v="136" actId="1036"/>
          <ac:spMkLst>
            <pc:docMk/>
            <pc:sldMk cId="539791449" sldId="269"/>
            <ac:spMk id="17" creationId="{EEEFA706-C14E-29CE-11E0-3BF9E16743E9}"/>
          </ac:spMkLst>
        </pc:spChg>
        <pc:spChg chg="mod">
          <ac:chgData name="Al-Odat, Omar Sami Faleh" userId="00ed9233-b732-4002-afb5-4e27259fd0a0" providerId="ADAL" clId="{F393D814-7CDA-4B7C-AEBF-D850F038BB7F}" dt="2024-01-08T00:55:55.769" v="136" actId="1036"/>
          <ac:spMkLst>
            <pc:docMk/>
            <pc:sldMk cId="539791449" sldId="269"/>
            <ac:spMk id="21" creationId="{58041CEF-4698-3BFC-0D51-30B59B18A816}"/>
          </ac:spMkLst>
        </pc:spChg>
        <pc:spChg chg="del">
          <ac:chgData name="Al-Odat, Omar Sami Faleh" userId="00ed9233-b732-4002-afb5-4e27259fd0a0" providerId="ADAL" clId="{F393D814-7CDA-4B7C-AEBF-D850F038BB7F}" dt="2024-01-08T00:55:30.084" v="110" actId="478"/>
          <ac:spMkLst>
            <pc:docMk/>
            <pc:sldMk cId="539791449" sldId="269"/>
            <ac:spMk id="23" creationId="{EF477021-34D3-2FFB-06A5-F68A292E33B8}"/>
          </ac:spMkLst>
        </pc:spChg>
        <pc:spChg chg="mod">
          <ac:chgData name="Al-Odat, Omar Sami Faleh" userId="00ed9233-b732-4002-afb5-4e27259fd0a0" providerId="ADAL" clId="{F393D814-7CDA-4B7C-AEBF-D850F038BB7F}" dt="2024-01-08T00:55:55.769" v="136" actId="1036"/>
          <ac:spMkLst>
            <pc:docMk/>
            <pc:sldMk cId="539791449" sldId="269"/>
            <ac:spMk id="26" creationId="{CE818360-92F0-E389-3CAB-54C0E840772F}"/>
          </ac:spMkLst>
        </pc:spChg>
        <pc:spChg chg="mod">
          <ac:chgData name="Al-Odat, Omar Sami Faleh" userId="00ed9233-b732-4002-afb5-4e27259fd0a0" providerId="ADAL" clId="{F393D814-7CDA-4B7C-AEBF-D850F038BB7F}" dt="2024-01-08T00:56:02.296" v="161" actId="1035"/>
          <ac:spMkLst>
            <pc:docMk/>
            <pc:sldMk cId="539791449" sldId="269"/>
            <ac:spMk id="30" creationId="{595D95D5-E62F-2341-82BD-C629058643F6}"/>
          </ac:spMkLst>
        </pc:spChg>
        <pc:graphicFrameChg chg="mod">
          <ac:chgData name="Al-Odat, Omar Sami Faleh" userId="00ed9233-b732-4002-afb5-4e27259fd0a0" providerId="ADAL" clId="{F393D814-7CDA-4B7C-AEBF-D850F038BB7F}" dt="2024-01-08T00:55:55.769" v="136" actId="1036"/>
          <ac:graphicFrameMkLst>
            <pc:docMk/>
            <pc:sldMk cId="539791449" sldId="269"/>
            <ac:graphicFrameMk id="11" creationId="{796CC80D-45B8-C761-4789-DEFB224C0359}"/>
          </ac:graphicFrameMkLst>
        </pc:graphicFrameChg>
        <pc:graphicFrameChg chg="mod">
          <ac:chgData name="Al-Odat, Omar Sami Faleh" userId="00ed9233-b732-4002-afb5-4e27259fd0a0" providerId="ADAL" clId="{F393D814-7CDA-4B7C-AEBF-D850F038BB7F}" dt="2024-01-08T00:55:55.769" v="136" actId="1036"/>
          <ac:graphicFrameMkLst>
            <pc:docMk/>
            <pc:sldMk cId="539791449" sldId="269"/>
            <ac:graphicFrameMk id="12" creationId="{203B53DA-1A44-AEB8-C243-7E4435F7D1DF}"/>
          </ac:graphicFrameMkLst>
        </pc:graphicFrameChg>
        <pc:graphicFrameChg chg="mod">
          <ac:chgData name="Al-Odat, Omar Sami Faleh" userId="00ed9233-b732-4002-afb5-4e27259fd0a0" providerId="ADAL" clId="{F393D814-7CDA-4B7C-AEBF-D850F038BB7F}" dt="2024-01-08T00:55:55.769" v="136" actId="1036"/>
          <ac:graphicFrameMkLst>
            <pc:docMk/>
            <pc:sldMk cId="539791449" sldId="269"/>
            <ac:graphicFrameMk id="13" creationId="{5671D3CD-437B-F9E9-6EE2-DE0014663B20}"/>
          </ac:graphicFrameMkLst>
        </pc:graphicFrameChg>
        <pc:graphicFrameChg chg="del">
          <ac:chgData name="Al-Odat, Omar Sami Faleh" userId="00ed9233-b732-4002-afb5-4e27259fd0a0" providerId="ADAL" clId="{F393D814-7CDA-4B7C-AEBF-D850F038BB7F}" dt="2024-01-08T00:54:32.986" v="93" actId="478"/>
          <ac:graphicFrameMkLst>
            <pc:docMk/>
            <pc:sldMk cId="539791449" sldId="269"/>
            <ac:graphicFrameMk id="16" creationId="{8882DD6F-50A2-D5EC-8709-B13390C9F199}"/>
          </ac:graphicFrameMkLst>
        </pc:graphicFrameChg>
        <pc:graphicFrameChg chg="del">
          <ac:chgData name="Al-Odat, Omar Sami Faleh" userId="00ed9233-b732-4002-afb5-4e27259fd0a0" providerId="ADAL" clId="{F393D814-7CDA-4B7C-AEBF-D850F038BB7F}" dt="2024-01-08T00:54:33.660" v="94" actId="478"/>
          <ac:graphicFrameMkLst>
            <pc:docMk/>
            <pc:sldMk cId="539791449" sldId="269"/>
            <ac:graphicFrameMk id="18" creationId="{632455AA-9911-B42F-52C6-3269AABE3B35}"/>
          </ac:graphicFrameMkLst>
        </pc:graphicFrameChg>
        <pc:graphicFrameChg chg="del">
          <ac:chgData name="Al-Odat, Omar Sami Faleh" userId="00ed9233-b732-4002-afb5-4e27259fd0a0" providerId="ADAL" clId="{F393D814-7CDA-4B7C-AEBF-D850F038BB7F}" dt="2024-01-08T00:54:34.320" v="95" actId="478"/>
          <ac:graphicFrameMkLst>
            <pc:docMk/>
            <pc:sldMk cId="539791449" sldId="269"/>
            <ac:graphicFrameMk id="19" creationId="{6CE481C7-5930-7CFD-DDC3-96BC02B302C5}"/>
          </ac:graphicFrameMkLst>
        </pc:graphicFrameChg>
        <pc:picChg chg="del">
          <ac:chgData name="Al-Odat, Omar Sami Faleh" userId="00ed9233-b732-4002-afb5-4e27259fd0a0" providerId="ADAL" clId="{F393D814-7CDA-4B7C-AEBF-D850F038BB7F}" dt="2024-01-08T00:54:34.914" v="96" actId="478"/>
          <ac:picMkLst>
            <pc:docMk/>
            <pc:sldMk cId="539791449" sldId="269"/>
            <ac:picMk id="2" creationId="{EBDC3FE1-5327-EEA8-CC5C-A0A6099A3C92}"/>
          </ac:picMkLst>
        </pc:picChg>
        <pc:picChg chg="mod">
          <ac:chgData name="Al-Odat, Omar Sami Faleh" userId="00ed9233-b732-4002-afb5-4e27259fd0a0" providerId="ADAL" clId="{F393D814-7CDA-4B7C-AEBF-D850F038BB7F}" dt="2024-01-08T00:55:55.769" v="136" actId="1036"/>
          <ac:picMkLst>
            <pc:docMk/>
            <pc:sldMk cId="539791449" sldId="269"/>
            <ac:picMk id="4" creationId="{F7879CC5-50C4-A1EB-97C5-82CF573374B9}"/>
          </ac:picMkLst>
        </pc:picChg>
        <pc:picChg chg="add del mod">
          <ac:chgData name="Al-Odat, Omar Sami Faleh" userId="00ed9233-b732-4002-afb5-4e27259fd0a0" providerId="ADAL" clId="{F393D814-7CDA-4B7C-AEBF-D850F038BB7F}" dt="2024-01-08T00:55:55.769" v="136" actId="1036"/>
          <ac:picMkLst>
            <pc:docMk/>
            <pc:sldMk cId="539791449" sldId="269"/>
            <ac:picMk id="7" creationId="{3120156E-BCD3-3CED-23C3-E571702DB62F}"/>
          </ac:picMkLst>
        </pc:picChg>
        <pc:picChg chg="mod">
          <ac:chgData name="Al-Odat, Omar Sami Faleh" userId="00ed9233-b732-4002-afb5-4e27259fd0a0" providerId="ADAL" clId="{F393D814-7CDA-4B7C-AEBF-D850F038BB7F}" dt="2024-01-08T00:55:55.769" v="136" actId="1036"/>
          <ac:picMkLst>
            <pc:docMk/>
            <pc:sldMk cId="539791449" sldId="269"/>
            <ac:picMk id="8" creationId="{C0623240-4A50-FF4C-BB52-1158EF4E86B1}"/>
          </ac:picMkLst>
        </pc:picChg>
        <pc:picChg chg="mod">
          <ac:chgData name="Al-Odat, Omar Sami Faleh" userId="00ed9233-b732-4002-afb5-4e27259fd0a0" providerId="ADAL" clId="{F393D814-7CDA-4B7C-AEBF-D850F038BB7F}" dt="2024-01-08T00:55:55.769" v="136" actId="1036"/>
          <ac:picMkLst>
            <pc:docMk/>
            <pc:sldMk cId="539791449" sldId="269"/>
            <ac:picMk id="9" creationId="{2A12B986-63B7-79F1-1A84-B6443B552280}"/>
          </ac:picMkLst>
        </pc:picChg>
        <pc:picChg chg="mod">
          <ac:chgData name="Al-Odat, Omar Sami Faleh" userId="00ed9233-b732-4002-afb5-4e27259fd0a0" providerId="ADAL" clId="{F393D814-7CDA-4B7C-AEBF-D850F038BB7F}" dt="2024-01-08T00:55:55.769" v="136" actId="1036"/>
          <ac:picMkLst>
            <pc:docMk/>
            <pc:sldMk cId="539791449" sldId="269"/>
            <ac:picMk id="14" creationId="{712ED87A-6E0E-4BFD-CDA8-7E19970B9B06}"/>
          </ac:picMkLst>
        </pc:picChg>
      </pc:sldChg>
      <pc:sldChg chg="addSp delSp modSp mod">
        <pc:chgData name="Al-Odat, Omar Sami Faleh" userId="00ed9233-b732-4002-afb5-4e27259fd0a0" providerId="ADAL" clId="{F393D814-7CDA-4B7C-AEBF-D850F038BB7F}" dt="2024-01-08T00:18:21.679" v="32" actId="478"/>
        <pc:sldMkLst>
          <pc:docMk/>
          <pc:sldMk cId="1073319666" sldId="271"/>
        </pc:sldMkLst>
        <pc:graphicFrameChg chg="add mod">
          <ac:chgData name="Al-Odat, Omar Sami Faleh" userId="00ed9233-b732-4002-afb5-4e27259fd0a0" providerId="ADAL" clId="{F393D814-7CDA-4B7C-AEBF-D850F038BB7F}" dt="2024-01-08T00:18:19.275" v="31" actId="1076"/>
          <ac:graphicFrameMkLst>
            <pc:docMk/>
            <pc:sldMk cId="1073319666" sldId="271"/>
            <ac:graphicFrameMk id="6" creationId="{68DB6CF2-6E3D-E55F-4D14-38CA22FE7645}"/>
          </ac:graphicFrameMkLst>
        </pc:graphicFrameChg>
        <pc:graphicFrameChg chg="del mod">
          <ac:chgData name="Al-Odat, Omar Sami Faleh" userId="00ed9233-b732-4002-afb5-4e27259fd0a0" providerId="ADAL" clId="{F393D814-7CDA-4B7C-AEBF-D850F038BB7F}" dt="2024-01-08T00:18:21.679" v="32" actId="478"/>
          <ac:graphicFrameMkLst>
            <pc:docMk/>
            <pc:sldMk cId="1073319666" sldId="271"/>
            <ac:graphicFrameMk id="46" creationId="{4FCF1081-8036-CC8F-3464-1F926F76A3E0}"/>
          </ac:graphicFrameMkLst>
        </pc:graphicFrameChg>
      </pc:sldChg>
    </pc:docChg>
  </pc:docChgLst>
  <pc:docChgLst>
    <pc:chgData name="Al-Odat, Omar Sami Faleh" userId="00ed9233-b732-4002-afb5-4e27259fd0a0" providerId="ADAL" clId="{41F2318A-0007-4047-87BA-642E6DA488BE}"/>
    <pc:docChg chg="undo custSel addSld delSld modSld sldOrd">
      <pc:chgData name="Al-Odat, Omar Sami Faleh" userId="00ed9233-b732-4002-afb5-4e27259fd0a0" providerId="ADAL" clId="{41F2318A-0007-4047-87BA-642E6DA488BE}" dt="2024-04-27T01:24:47.976" v="158" actId="1076"/>
      <pc:docMkLst>
        <pc:docMk/>
      </pc:docMkLst>
      <pc:sldChg chg="addSp delSp modSp mod">
        <pc:chgData name="Al-Odat, Omar Sami Faleh" userId="00ed9233-b732-4002-afb5-4e27259fd0a0" providerId="ADAL" clId="{41F2318A-0007-4047-87BA-642E6DA488BE}" dt="2024-04-27T01:24:47.976" v="158" actId="1076"/>
        <pc:sldMkLst>
          <pc:docMk/>
          <pc:sldMk cId="2971561120" sldId="264"/>
        </pc:sldMkLst>
        <pc:spChg chg="add mod">
          <ac:chgData name="Al-Odat, Omar Sami Faleh" userId="00ed9233-b732-4002-afb5-4e27259fd0a0" providerId="ADAL" clId="{41F2318A-0007-4047-87BA-642E6DA488BE}" dt="2024-04-24T18:13:18.957" v="67" actId="20577"/>
          <ac:spMkLst>
            <pc:docMk/>
            <pc:sldMk cId="2971561120" sldId="264"/>
            <ac:spMk id="2" creationId="{9C4FD6E7-F27F-8181-D5CE-80DEE3ADB98B}"/>
          </ac:spMkLst>
        </pc:spChg>
        <pc:spChg chg="add mod">
          <ac:chgData name="Al-Odat, Omar Sami Faleh" userId="00ed9233-b732-4002-afb5-4e27259fd0a0" providerId="ADAL" clId="{41F2318A-0007-4047-87BA-642E6DA488BE}" dt="2024-04-24T18:15:06.886" v="85" actId="20577"/>
          <ac:spMkLst>
            <pc:docMk/>
            <pc:sldMk cId="2971561120" sldId="264"/>
            <ac:spMk id="3" creationId="{321F2EA4-BA93-1393-693A-945A080DFD00}"/>
          </ac:spMkLst>
        </pc:spChg>
        <pc:spChg chg="add del mod">
          <ac:chgData name="Al-Odat, Omar Sami Faleh" userId="00ed9233-b732-4002-afb5-4e27259fd0a0" providerId="ADAL" clId="{41F2318A-0007-4047-87BA-642E6DA488BE}" dt="2024-04-24T18:14:48.143" v="82" actId="20577"/>
          <ac:spMkLst>
            <pc:docMk/>
            <pc:sldMk cId="2971561120" sldId="264"/>
            <ac:spMk id="5" creationId="{B7385783-D12A-B85D-E132-3C6ED3B3447F}"/>
          </ac:spMkLst>
        </pc:spChg>
        <pc:spChg chg="mod">
          <ac:chgData name="Al-Odat, Omar Sami Faleh" userId="00ed9233-b732-4002-afb5-4e27259fd0a0" providerId="ADAL" clId="{41F2318A-0007-4047-87BA-642E6DA488BE}" dt="2024-04-27T01:24:45.333" v="157" actId="1076"/>
          <ac:spMkLst>
            <pc:docMk/>
            <pc:sldMk cId="2971561120" sldId="264"/>
            <ac:spMk id="9" creationId="{E5AA7A2D-0EAE-96C5-5B7A-D6D5604EDF46}"/>
          </ac:spMkLst>
        </pc:spChg>
        <pc:spChg chg="mod">
          <ac:chgData name="Al-Odat, Omar Sami Faleh" userId="00ed9233-b732-4002-afb5-4e27259fd0a0" providerId="ADAL" clId="{41F2318A-0007-4047-87BA-642E6DA488BE}" dt="2024-04-27T01:24:47.976" v="158" actId="1076"/>
          <ac:spMkLst>
            <pc:docMk/>
            <pc:sldMk cId="2971561120" sldId="264"/>
            <ac:spMk id="11" creationId="{1EB4ACAB-B60C-AE77-3F2C-14C13D1CE370}"/>
          </ac:spMkLst>
        </pc:spChg>
        <pc:spChg chg="mod">
          <ac:chgData name="Al-Odat, Omar Sami Faleh" userId="00ed9233-b732-4002-afb5-4e27259fd0a0" providerId="ADAL" clId="{41F2318A-0007-4047-87BA-642E6DA488BE}" dt="2024-04-24T18:15:29.622" v="90" actId="20577"/>
          <ac:spMkLst>
            <pc:docMk/>
            <pc:sldMk cId="2971561120" sldId="264"/>
            <ac:spMk id="12" creationId="{E9E776ED-8215-3D10-EF97-6EBEC535165C}"/>
          </ac:spMkLst>
        </pc:spChg>
        <pc:spChg chg="del">
          <ac:chgData name="Al-Odat, Omar Sami Faleh" userId="00ed9233-b732-4002-afb5-4e27259fd0a0" providerId="ADAL" clId="{41F2318A-0007-4047-87BA-642E6DA488BE}" dt="2024-04-24T18:01:54.857" v="36" actId="478"/>
          <ac:spMkLst>
            <pc:docMk/>
            <pc:sldMk cId="2971561120" sldId="264"/>
            <ac:spMk id="14" creationId="{26021577-B265-58D5-7438-365B87876AF9}"/>
          </ac:spMkLst>
        </pc:spChg>
        <pc:spChg chg="del">
          <ac:chgData name="Al-Odat, Omar Sami Faleh" userId="00ed9233-b732-4002-afb5-4e27259fd0a0" providerId="ADAL" clId="{41F2318A-0007-4047-87BA-642E6DA488BE}" dt="2024-04-24T18:01:50.105" v="35" actId="478"/>
          <ac:spMkLst>
            <pc:docMk/>
            <pc:sldMk cId="2971561120" sldId="264"/>
            <ac:spMk id="15" creationId="{7510C961-E30E-72EF-03B1-063E5BE0246D}"/>
          </ac:spMkLst>
        </pc:spChg>
        <pc:spChg chg="mod">
          <ac:chgData name="Al-Odat, Omar Sami Faleh" userId="00ed9233-b732-4002-afb5-4e27259fd0a0" providerId="ADAL" clId="{41F2318A-0007-4047-87BA-642E6DA488BE}" dt="2024-04-24T18:14:44.464" v="81" actId="20577"/>
          <ac:spMkLst>
            <pc:docMk/>
            <pc:sldMk cId="2971561120" sldId="264"/>
            <ac:spMk id="22" creationId="{D36BB31D-2D26-F507-652B-9D039966D581}"/>
          </ac:spMkLst>
        </pc:spChg>
        <pc:spChg chg="del">
          <ac:chgData name="Al-Odat, Omar Sami Faleh" userId="00ed9233-b732-4002-afb5-4e27259fd0a0" providerId="ADAL" clId="{41F2318A-0007-4047-87BA-642E6DA488BE}" dt="2024-04-24T18:01:50.105" v="35" actId="478"/>
          <ac:spMkLst>
            <pc:docMk/>
            <pc:sldMk cId="2971561120" sldId="264"/>
            <ac:spMk id="28" creationId="{8CF43914-9E55-A249-B114-0DCB10BC61E6}"/>
          </ac:spMkLst>
        </pc:spChg>
        <pc:spChg chg="mod">
          <ac:chgData name="Al-Odat, Omar Sami Faleh" userId="00ed9233-b732-4002-afb5-4e27259fd0a0" providerId="ADAL" clId="{41F2318A-0007-4047-87BA-642E6DA488BE}" dt="2024-04-24T17:58:48.742" v="1" actId="20577"/>
          <ac:spMkLst>
            <pc:docMk/>
            <pc:sldMk cId="2971561120" sldId="264"/>
            <ac:spMk id="30" creationId="{595D95D5-E62F-2341-82BD-C629058643F6}"/>
          </ac:spMkLst>
        </pc:spChg>
        <pc:spChg chg="del">
          <ac:chgData name="Al-Odat, Omar Sami Faleh" userId="00ed9233-b732-4002-afb5-4e27259fd0a0" providerId="ADAL" clId="{41F2318A-0007-4047-87BA-642E6DA488BE}" dt="2024-04-24T18:01:50.105" v="35" actId="478"/>
          <ac:spMkLst>
            <pc:docMk/>
            <pc:sldMk cId="2971561120" sldId="264"/>
            <ac:spMk id="118" creationId="{28E4AB3B-1983-5A11-AF9B-BE6F3A5CCF08}"/>
          </ac:spMkLst>
        </pc:spChg>
        <pc:graphicFrameChg chg="add mod">
          <ac:chgData name="Al-Odat, Omar Sami Faleh" userId="00ed9233-b732-4002-afb5-4e27259fd0a0" providerId="ADAL" clId="{41F2318A-0007-4047-87BA-642E6DA488BE}" dt="2024-04-24T18:02:59.215" v="52" actId="1076"/>
          <ac:graphicFrameMkLst>
            <pc:docMk/>
            <pc:sldMk cId="2971561120" sldId="264"/>
            <ac:graphicFrameMk id="4" creationId="{FC30E3A6-1460-2F02-D72C-007610C659F1}"/>
          </ac:graphicFrameMkLst>
        </pc:graphicFrameChg>
        <pc:graphicFrameChg chg="add mod">
          <ac:chgData name="Al-Odat, Omar Sami Faleh" userId="00ed9233-b732-4002-afb5-4e27259fd0a0" providerId="ADAL" clId="{41F2318A-0007-4047-87BA-642E6DA488BE}" dt="2024-04-24T18:02:59.215" v="52" actId="1076"/>
          <ac:graphicFrameMkLst>
            <pc:docMk/>
            <pc:sldMk cId="2971561120" sldId="264"/>
            <ac:graphicFrameMk id="8" creationId="{16B8C8CA-4AEC-002D-BFD1-FC16FDB2B1E4}"/>
          </ac:graphicFrameMkLst>
        </pc:graphicFrameChg>
        <pc:graphicFrameChg chg="mod">
          <ac:chgData name="Al-Odat, Omar Sami Faleh" userId="00ed9233-b732-4002-afb5-4e27259fd0a0" providerId="ADAL" clId="{41F2318A-0007-4047-87BA-642E6DA488BE}" dt="2024-04-24T18:02:59.215" v="52" actId="1076"/>
          <ac:graphicFrameMkLst>
            <pc:docMk/>
            <pc:sldMk cId="2971561120" sldId="264"/>
            <ac:graphicFrameMk id="10" creationId="{A34BCB61-4981-8960-35EE-7BD95C67C5B0}"/>
          </ac:graphicFrameMkLst>
        </pc:graphicFrameChg>
        <pc:graphicFrameChg chg="mod">
          <ac:chgData name="Al-Odat, Omar Sami Faleh" userId="00ed9233-b732-4002-afb5-4e27259fd0a0" providerId="ADAL" clId="{41F2318A-0007-4047-87BA-642E6DA488BE}" dt="2024-04-24T18:02:59.215" v="52" actId="1076"/>
          <ac:graphicFrameMkLst>
            <pc:docMk/>
            <pc:sldMk cId="2971561120" sldId="264"/>
            <ac:graphicFrameMk id="13" creationId="{CAA7F340-42B2-6AE0-5FB7-0AA4918AF153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8:01:50.105" v="35" actId="478"/>
          <ac:graphicFrameMkLst>
            <pc:docMk/>
            <pc:sldMk cId="2971561120" sldId="264"/>
            <ac:graphicFrameMk id="17" creationId="{DB342948-225C-C919-F012-7CC4179F87BA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8:01:50.105" v="35" actId="478"/>
          <ac:graphicFrameMkLst>
            <pc:docMk/>
            <pc:sldMk cId="2971561120" sldId="264"/>
            <ac:graphicFrameMk id="18" creationId="{54A61834-FF9B-767E-16BC-CB800FD84D5A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8:01:50.105" v="35" actId="478"/>
          <ac:graphicFrameMkLst>
            <pc:docMk/>
            <pc:sldMk cId="2971561120" sldId="264"/>
            <ac:graphicFrameMk id="25" creationId="{5B41EB5B-3D5B-406A-7561-86E514C48F29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8:01:50.105" v="35" actId="478"/>
          <ac:graphicFrameMkLst>
            <pc:docMk/>
            <pc:sldMk cId="2971561120" sldId="264"/>
            <ac:graphicFrameMk id="26" creationId="{C4E0B28B-3808-FAE4-B9E5-6586138E6ACA}"/>
          </ac:graphicFrameMkLst>
        </pc:graphicFrameChg>
        <pc:graphicFrameChg chg="mod">
          <ac:chgData name="Al-Odat, Omar Sami Faleh" userId="00ed9233-b732-4002-afb5-4e27259fd0a0" providerId="ADAL" clId="{41F2318A-0007-4047-87BA-642E6DA488BE}" dt="2024-04-24T18:02:59.215" v="52" actId="1076"/>
          <ac:graphicFrameMkLst>
            <pc:docMk/>
            <pc:sldMk cId="2971561120" sldId="264"/>
            <ac:graphicFrameMk id="27" creationId="{A488B49F-94B4-263F-88EE-22F5349171D1}"/>
          </ac:graphicFrameMkLst>
        </pc:graphicFrameChg>
        <pc:graphicFrameChg chg="mod">
          <ac:chgData name="Al-Odat, Omar Sami Faleh" userId="00ed9233-b732-4002-afb5-4e27259fd0a0" providerId="ADAL" clId="{41F2318A-0007-4047-87BA-642E6DA488BE}" dt="2024-04-24T18:02:59.215" v="52" actId="1076"/>
          <ac:graphicFrameMkLst>
            <pc:docMk/>
            <pc:sldMk cId="2971561120" sldId="264"/>
            <ac:graphicFrameMk id="29" creationId="{68F26A1C-CD29-5043-19D0-3E9026BF5341}"/>
          </ac:graphicFrameMkLst>
        </pc:graphicFrameChg>
        <pc:picChg chg="del">
          <ac:chgData name="Al-Odat, Omar Sami Faleh" userId="00ed9233-b732-4002-afb5-4e27259fd0a0" providerId="ADAL" clId="{41F2318A-0007-4047-87BA-642E6DA488BE}" dt="2024-04-24T18:01:50.105" v="35" actId="478"/>
          <ac:picMkLst>
            <pc:docMk/>
            <pc:sldMk cId="2971561120" sldId="264"/>
            <ac:picMk id="6" creationId="{599D8FAB-A9D1-15CE-4DDA-B782FA75AD46}"/>
          </ac:picMkLst>
        </pc:picChg>
        <pc:picChg chg="del">
          <ac:chgData name="Al-Odat, Omar Sami Faleh" userId="00ed9233-b732-4002-afb5-4e27259fd0a0" providerId="ADAL" clId="{41F2318A-0007-4047-87BA-642E6DA488BE}" dt="2024-04-24T18:01:50.105" v="35" actId="478"/>
          <ac:picMkLst>
            <pc:docMk/>
            <pc:sldMk cId="2971561120" sldId="264"/>
            <ac:picMk id="7" creationId="{3F58AEF9-DB0D-E7F5-EFDF-D9786E221096}"/>
          </ac:picMkLst>
        </pc:picChg>
        <pc:picChg chg="del">
          <ac:chgData name="Al-Odat, Omar Sami Faleh" userId="00ed9233-b732-4002-afb5-4e27259fd0a0" providerId="ADAL" clId="{41F2318A-0007-4047-87BA-642E6DA488BE}" dt="2024-04-24T18:01:50.105" v="35" actId="478"/>
          <ac:picMkLst>
            <pc:docMk/>
            <pc:sldMk cId="2971561120" sldId="264"/>
            <ac:picMk id="16" creationId="{4083B46A-CE54-E55D-30D5-AB6FD1896CD6}"/>
          </ac:picMkLst>
        </pc:picChg>
        <pc:picChg chg="mod">
          <ac:chgData name="Al-Odat, Omar Sami Faleh" userId="00ed9233-b732-4002-afb5-4e27259fd0a0" providerId="ADAL" clId="{41F2318A-0007-4047-87BA-642E6DA488BE}" dt="2024-04-24T18:02:59.215" v="52" actId="1076"/>
          <ac:picMkLst>
            <pc:docMk/>
            <pc:sldMk cId="2971561120" sldId="264"/>
            <ac:picMk id="21" creationId="{BC0CECD4-6AC6-B40B-DFF8-D379D7C72E0A}"/>
          </ac:picMkLst>
        </pc:picChg>
        <pc:picChg chg="mod">
          <ac:chgData name="Al-Odat, Omar Sami Faleh" userId="00ed9233-b732-4002-afb5-4e27259fd0a0" providerId="ADAL" clId="{41F2318A-0007-4047-87BA-642E6DA488BE}" dt="2024-04-24T18:02:59.215" v="52" actId="1076"/>
          <ac:picMkLst>
            <pc:docMk/>
            <pc:sldMk cId="2971561120" sldId="264"/>
            <ac:picMk id="23" creationId="{DF4A4556-65FF-CB2F-7740-F5F717779D78}"/>
          </ac:picMkLst>
        </pc:picChg>
        <pc:picChg chg="mod">
          <ac:chgData name="Al-Odat, Omar Sami Faleh" userId="00ed9233-b732-4002-afb5-4e27259fd0a0" providerId="ADAL" clId="{41F2318A-0007-4047-87BA-642E6DA488BE}" dt="2024-04-24T18:02:59.215" v="52" actId="1076"/>
          <ac:picMkLst>
            <pc:docMk/>
            <pc:sldMk cId="2971561120" sldId="264"/>
            <ac:picMk id="24" creationId="{6AAC207B-DD94-5A23-66C4-CC9F48311D19}"/>
          </ac:picMkLst>
        </pc:picChg>
        <pc:picChg chg="add mod">
          <ac:chgData name="Al-Odat, Omar Sami Faleh" userId="00ed9233-b732-4002-afb5-4e27259fd0a0" providerId="ADAL" clId="{41F2318A-0007-4047-87BA-642E6DA488BE}" dt="2024-04-24T18:02:59.215" v="52" actId="1076"/>
          <ac:picMkLst>
            <pc:docMk/>
            <pc:sldMk cId="2971561120" sldId="264"/>
            <ac:picMk id="54" creationId="{DE2A454F-3995-56E1-25FA-A133EABD3482}"/>
          </ac:picMkLst>
        </pc:picChg>
        <pc:picChg chg="add mod">
          <ac:chgData name="Al-Odat, Omar Sami Faleh" userId="00ed9233-b732-4002-afb5-4e27259fd0a0" providerId="ADAL" clId="{41F2318A-0007-4047-87BA-642E6DA488BE}" dt="2024-04-24T18:02:59.215" v="52" actId="1076"/>
          <ac:picMkLst>
            <pc:docMk/>
            <pc:sldMk cId="2971561120" sldId="264"/>
            <ac:picMk id="67" creationId="{6E860B93-428D-11CD-5FAB-F6C0B8BA2E8C}"/>
          </ac:picMkLst>
        </pc:picChg>
        <pc:picChg chg="add mod">
          <ac:chgData name="Al-Odat, Omar Sami Faleh" userId="00ed9233-b732-4002-afb5-4e27259fd0a0" providerId="ADAL" clId="{41F2318A-0007-4047-87BA-642E6DA488BE}" dt="2024-04-24T18:02:59.215" v="52" actId="1076"/>
          <ac:picMkLst>
            <pc:docMk/>
            <pc:sldMk cId="2971561120" sldId="264"/>
            <ac:picMk id="86" creationId="{2A883C78-F696-5E02-3CEF-7C43449C2B64}"/>
          </ac:picMkLst>
        </pc:picChg>
      </pc:sldChg>
      <pc:sldChg chg="modSp mod">
        <pc:chgData name="Al-Odat, Omar Sami Faleh" userId="00ed9233-b732-4002-afb5-4e27259fd0a0" providerId="ADAL" clId="{41F2318A-0007-4047-87BA-642E6DA488BE}" dt="2024-04-24T18:03:27.061" v="57" actId="20577"/>
        <pc:sldMkLst>
          <pc:docMk/>
          <pc:sldMk cId="539791449" sldId="269"/>
        </pc:sldMkLst>
        <pc:spChg chg="mod">
          <ac:chgData name="Al-Odat, Omar Sami Faleh" userId="00ed9233-b732-4002-afb5-4e27259fd0a0" providerId="ADAL" clId="{41F2318A-0007-4047-87BA-642E6DA488BE}" dt="2024-04-24T18:03:27.061" v="57" actId="20577"/>
          <ac:spMkLst>
            <pc:docMk/>
            <pc:sldMk cId="539791449" sldId="269"/>
            <ac:spMk id="30" creationId="{595D95D5-E62F-2341-82BD-C629058643F6}"/>
          </ac:spMkLst>
        </pc:spChg>
      </pc:sldChg>
      <pc:sldChg chg="addSp delSp modSp mod">
        <pc:chgData name="Al-Odat, Omar Sami Faleh" userId="00ed9233-b732-4002-afb5-4e27259fd0a0" providerId="ADAL" clId="{41F2318A-0007-4047-87BA-642E6DA488BE}" dt="2024-04-27T01:23:42.533" v="153" actId="1038"/>
        <pc:sldMkLst>
          <pc:docMk/>
          <pc:sldMk cId="1073319666" sldId="271"/>
        </pc:sldMkLst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26" creationId="{9305BF4D-52A5-8559-9D7E-7FD5D19EAFEC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29" creationId="{33AF3521-6346-7644-8E3C-3E860A84B49D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31" creationId="{B52BCB87-7021-0DBE-724E-208F2743A3ED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35" creationId="{6244C420-A184-75ED-704F-968B8E10807E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39" creationId="{93CC1EC9-CAEA-36BC-1101-BF537E7997B4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40" creationId="{AA8CAF17-6F8B-CB7B-E81D-8765F9ACC495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41" creationId="{EBE5F814-0DC5-CA0C-8C81-09BBC0BEDC09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42" creationId="{483DD994-801D-F58F-03FE-C3947D46A54A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43" creationId="{9787E300-5704-B66F-EA18-22B562973F11}"/>
          </ac:spMkLst>
        </pc:spChg>
        <pc:spChg chg="mod">
          <ac:chgData name="Al-Odat, Omar Sami Faleh" userId="00ed9233-b732-4002-afb5-4e27259fd0a0" providerId="ADAL" clId="{41F2318A-0007-4047-87BA-642E6DA488BE}" dt="2024-04-25T19:17:24.490" v="106"/>
          <ac:spMkLst>
            <pc:docMk/>
            <pc:sldMk cId="1073319666" sldId="271"/>
            <ac:spMk id="44" creationId="{A6FBB814-5E18-DBFA-9852-92049B0BBD80}"/>
          </ac:spMkLst>
        </pc:spChg>
        <pc:grpChg chg="add mod">
          <ac:chgData name="Al-Odat, Omar Sami Faleh" userId="00ed9233-b732-4002-afb5-4e27259fd0a0" providerId="ADAL" clId="{41F2318A-0007-4047-87BA-642E6DA488BE}" dt="2024-04-25T19:17:31.165" v="110" actId="1076"/>
          <ac:grpSpMkLst>
            <pc:docMk/>
            <pc:sldMk cId="1073319666" sldId="271"/>
            <ac:grpSpMk id="20" creationId="{164D40A8-20BF-5C2A-3309-70F5FE1B045E}"/>
          </ac:grpSpMkLst>
        </pc:grpChg>
        <pc:grpChg chg="mod">
          <ac:chgData name="Al-Odat, Omar Sami Faleh" userId="00ed9233-b732-4002-afb5-4e27259fd0a0" providerId="ADAL" clId="{41F2318A-0007-4047-87BA-642E6DA488BE}" dt="2024-04-25T19:17:24.490" v="106"/>
          <ac:grpSpMkLst>
            <pc:docMk/>
            <pc:sldMk cId="1073319666" sldId="271"/>
            <ac:grpSpMk id="22" creationId="{0C9DF680-F376-0212-F98D-55CC03825AD3}"/>
          </ac:grpSpMkLst>
        </pc:grpChg>
        <pc:grpChg chg="mod">
          <ac:chgData name="Al-Odat, Omar Sami Faleh" userId="00ed9233-b732-4002-afb5-4e27259fd0a0" providerId="ADAL" clId="{41F2318A-0007-4047-87BA-642E6DA488BE}" dt="2024-04-25T19:17:24.490" v="106"/>
          <ac:grpSpMkLst>
            <pc:docMk/>
            <pc:sldMk cId="1073319666" sldId="271"/>
            <ac:grpSpMk id="28" creationId="{763BAC56-6076-1605-23EF-52D8B6427B8B}"/>
          </ac:grpSpMkLst>
        </pc:grpChg>
        <pc:graphicFrameChg chg="mod">
          <ac:chgData name="Al-Odat, Omar Sami Faleh" userId="00ed9233-b732-4002-afb5-4e27259fd0a0" providerId="ADAL" clId="{41F2318A-0007-4047-87BA-642E6DA488BE}" dt="2024-04-27T01:23:42.533" v="153" actId="1038"/>
          <ac:graphicFrameMkLst>
            <pc:docMk/>
            <pc:sldMk cId="1073319666" sldId="271"/>
            <ac:graphicFrameMk id="6" creationId="{68DB6CF2-6E3D-E55F-4D14-38CA22FE7645}"/>
          </ac:graphicFrameMkLst>
        </pc:graphicFrameChg>
        <pc:picChg chg="add del mod">
          <ac:chgData name="Al-Odat, Omar Sami Faleh" userId="00ed9233-b732-4002-afb5-4e27259fd0a0" providerId="ADAL" clId="{41F2318A-0007-4047-87BA-642E6DA488BE}" dt="2024-04-25T18:56:53.332" v="98" actId="478"/>
          <ac:picMkLst>
            <pc:docMk/>
            <pc:sldMk cId="1073319666" sldId="271"/>
            <ac:picMk id="8" creationId="{FFCD32DA-358B-4A1D-C562-DAE1FF4E91DF}"/>
          </ac:picMkLst>
        </pc:picChg>
        <pc:picChg chg="add del">
          <ac:chgData name="Al-Odat, Omar Sami Faleh" userId="00ed9233-b732-4002-afb5-4e27259fd0a0" providerId="ADAL" clId="{41F2318A-0007-4047-87BA-642E6DA488BE}" dt="2024-04-25T18:44:53.506" v="97" actId="478"/>
          <ac:picMkLst>
            <pc:docMk/>
            <pc:sldMk cId="1073319666" sldId="271"/>
            <ac:picMk id="10" creationId="{8F0F92BE-3949-96E1-B5D2-940A23CEE890}"/>
          </ac:picMkLst>
        </pc:picChg>
        <pc:picChg chg="add del mod">
          <ac:chgData name="Al-Odat, Omar Sami Faleh" userId="00ed9233-b732-4002-afb5-4e27259fd0a0" providerId="ADAL" clId="{41F2318A-0007-4047-87BA-642E6DA488BE}" dt="2024-04-25T19:09:11.711" v="105" actId="21"/>
          <ac:picMkLst>
            <pc:docMk/>
            <pc:sldMk cId="1073319666" sldId="271"/>
            <ac:picMk id="15" creationId="{D8DDD459-9BC1-F75B-A272-ACB437F883C7}"/>
          </ac:picMkLst>
        </pc:picChg>
        <pc:picChg chg="add del mod">
          <ac:chgData name="Al-Odat, Omar Sami Faleh" userId="00ed9233-b732-4002-afb5-4e27259fd0a0" providerId="ADAL" clId="{41F2318A-0007-4047-87BA-642E6DA488BE}" dt="2024-04-25T19:09:11.711" v="105" actId="21"/>
          <ac:picMkLst>
            <pc:docMk/>
            <pc:sldMk cId="1073319666" sldId="271"/>
            <ac:picMk id="17" creationId="{80ECB755-287D-5DD2-AFD8-AF47BF299609}"/>
          </ac:picMkLst>
        </pc:picChg>
        <pc:picChg chg="add del">
          <ac:chgData name="Al-Odat, Omar Sami Faleh" userId="00ed9233-b732-4002-afb5-4e27259fd0a0" providerId="ADAL" clId="{41F2318A-0007-4047-87BA-642E6DA488BE}" dt="2024-04-25T19:09:11.711" v="105" actId="21"/>
          <ac:picMkLst>
            <pc:docMk/>
            <pc:sldMk cId="1073319666" sldId="271"/>
            <ac:picMk id="19" creationId="{5FD40F69-A51A-A591-0CCC-760CFB455BE1}"/>
          </ac:picMkLst>
        </pc:picChg>
        <pc:picChg chg="mod">
          <ac:chgData name="Al-Odat, Omar Sami Faleh" userId="00ed9233-b732-4002-afb5-4e27259fd0a0" providerId="ADAL" clId="{41F2318A-0007-4047-87BA-642E6DA488BE}" dt="2024-04-25T19:17:24.490" v="106"/>
          <ac:picMkLst>
            <pc:docMk/>
            <pc:sldMk cId="1073319666" sldId="271"/>
            <ac:picMk id="21" creationId="{E56C3A82-44AD-727A-A661-29C76970AFBC}"/>
          </ac:picMkLst>
        </pc:picChg>
        <pc:picChg chg="mod">
          <ac:chgData name="Al-Odat, Omar Sami Faleh" userId="00ed9233-b732-4002-afb5-4e27259fd0a0" providerId="ADAL" clId="{41F2318A-0007-4047-87BA-642E6DA488BE}" dt="2024-04-25T19:17:24.490" v="106"/>
          <ac:picMkLst>
            <pc:docMk/>
            <pc:sldMk cId="1073319666" sldId="271"/>
            <ac:picMk id="24" creationId="{CA12A8E5-701B-BC30-7824-73517872DF9F}"/>
          </ac:picMkLst>
        </pc:picChg>
        <pc:picChg chg="mod">
          <ac:chgData name="Al-Odat, Omar Sami Faleh" userId="00ed9233-b732-4002-afb5-4e27259fd0a0" providerId="ADAL" clId="{41F2318A-0007-4047-87BA-642E6DA488BE}" dt="2024-04-25T19:17:24.490" v="106"/>
          <ac:picMkLst>
            <pc:docMk/>
            <pc:sldMk cId="1073319666" sldId="271"/>
            <ac:picMk id="25" creationId="{28BEC7B3-1266-3CBB-4658-BF1C94C76DB9}"/>
          </ac:picMkLst>
        </pc:picChg>
        <pc:picChg chg="mod">
          <ac:chgData name="Al-Odat, Omar Sami Faleh" userId="00ed9233-b732-4002-afb5-4e27259fd0a0" providerId="ADAL" clId="{41F2318A-0007-4047-87BA-642E6DA488BE}" dt="2024-04-25T19:17:24.490" v="106"/>
          <ac:picMkLst>
            <pc:docMk/>
            <pc:sldMk cId="1073319666" sldId="271"/>
            <ac:picMk id="27" creationId="{9DD88F2A-74C9-9E72-E9FA-669A5FD51300}"/>
          </ac:picMkLst>
        </pc:picChg>
        <pc:picChg chg="mod">
          <ac:chgData name="Al-Odat, Omar Sami Faleh" userId="00ed9233-b732-4002-afb5-4e27259fd0a0" providerId="ADAL" clId="{41F2318A-0007-4047-87BA-642E6DA488BE}" dt="2024-04-25T19:17:24.490" v="106"/>
          <ac:picMkLst>
            <pc:docMk/>
            <pc:sldMk cId="1073319666" sldId="271"/>
            <ac:picMk id="32" creationId="{0562DAB6-242F-22A6-9F52-BB6D4EAC9615}"/>
          </ac:picMkLst>
        </pc:picChg>
        <pc:picChg chg="mod">
          <ac:chgData name="Al-Odat, Omar Sami Faleh" userId="00ed9233-b732-4002-afb5-4e27259fd0a0" providerId="ADAL" clId="{41F2318A-0007-4047-87BA-642E6DA488BE}" dt="2024-04-25T19:17:24.490" v="106"/>
          <ac:picMkLst>
            <pc:docMk/>
            <pc:sldMk cId="1073319666" sldId="271"/>
            <ac:picMk id="33" creationId="{FAE5B62B-3DE6-91DD-D4A0-139F61C58AB4}"/>
          </ac:picMkLst>
        </pc:picChg>
        <pc:picChg chg="mod">
          <ac:chgData name="Al-Odat, Omar Sami Faleh" userId="00ed9233-b732-4002-afb5-4e27259fd0a0" providerId="ADAL" clId="{41F2318A-0007-4047-87BA-642E6DA488BE}" dt="2024-04-25T19:17:24.490" v="106"/>
          <ac:picMkLst>
            <pc:docMk/>
            <pc:sldMk cId="1073319666" sldId="271"/>
            <ac:picMk id="34" creationId="{2FA84586-CF04-B5B9-8A4B-91259E2BB6D3}"/>
          </ac:picMkLst>
        </pc:picChg>
        <pc:picChg chg="add del mod">
          <ac:chgData name="Al-Odat, Omar Sami Faleh" userId="00ed9233-b732-4002-afb5-4e27259fd0a0" providerId="ADAL" clId="{41F2318A-0007-4047-87BA-642E6DA488BE}" dt="2024-04-25T19:19:56.110" v="143" actId="478"/>
          <ac:picMkLst>
            <pc:docMk/>
            <pc:sldMk cId="1073319666" sldId="271"/>
            <ac:picMk id="45" creationId="{9578A5CB-4AE2-3E18-40DB-E76C901E9776}"/>
          </ac:picMkLst>
        </pc:picChg>
        <pc:picChg chg="add mod">
          <ac:chgData name="Al-Odat, Omar Sami Faleh" userId="00ed9233-b732-4002-afb5-4e27259fd0a0" providerId="ADAL" clId="{41F2318A-0007-4047-87BA-642E6DA488BE}" dt="2024-04-25T19:20:04.229" v="149" actId="1037"/>
          <ac:picMkLst>
            <pc:docMk/>
            <pc:sldMk cId="1073319666" sldId="271"/>
            <ac:picMk id="46" creationId="{A0F2F09C-C0E9-2415-66EE-FEE8225E1CED}"/>
          </ac:picMkLst>
        </pc:picChg>
        <pc:picChg chg="del mod">
          <ac:chgData name="Al-Odat, Omar Sami Faleh" userId="00ed9233-b732-4002-afb5-4e27259fd0a0" providerId="ADAL" clId="{41F2318A-0007-4047-87BA-642E6DA488BE}" dt="2024-04-25T19:18:00.398" v="121" actId="478"/>
          <ac:picMkLst>
            <pc:docMk/>
            <pc:sldMk cId="1073319666" sldId="271"/>
            <ac:picMk id="47" creationId="{6B918E6A-3F7D-083C-CB59-B1A6B277599A}"/>
          </ac:picMkLst>
        </pc:picChg>
        <pc:cxnChg chg="mod">
          <ac:chgData name="Al-Odat, Omar Sami Faleh" userId="00ed9233-b732-4002-afb5-4e27259fd0a0" providerId="ADAL" clId="{41F2318A-0007-4047-87BA-642E6DA488BE}" dt="2024-04-25T19:17:24.490" v="106"/>
          <ac:cxnSpMkLst>
            <pc:docMk/>
            <pc:sldMk cId="1073319666" sldId="271"/>
            <ac:cxnSpMk id="23" creationId="{C0C4AD6D-6122-6852-A54F-CDA3A3215035}"/>
          </ac:cxnSpMkLst>
        </pc:cxnChg>
        <pc:cxnChg chg="mod">
          <ac:chgData name="Al-Odat, Omar Sami Faleh" userId="00ed9233-b732-4002-afb5-4e27259fd0a0" providerId="ADAL" clId="{41F2318A-0007-4047-87BA-642E6DA488BE}" dt="2024-04-25T19:17:24.490" v="106"/>
          <ac:cxnSpMkLst>
            <pc:docMk/>
            <pc:sldMk cId="1073319666" sldId="271"/>
            <ac:cxnSpMk id="36" creationId="{BE0B2E20-A5B9-CF67-FFD6-4AEE313D300E}"/>
          </ac:cxnSpMkLst>
        </pc:cxnChg>
        <pc:cxnChg chg="mod">
          <ac:chgData name="Al-Odat, Omar Sami Faleh" userId="00ed9233-b732-4002-afb5-4e27259fd0a0" providerId="ADAL" clId="{41F2318A-0007-4047-87BA-642E6DA488BE}" dt="2024-04-25T19:17:24.490" v="106"/>
          <ac:cxnSpMkLst>
            <pc:docMk/>
            <pc:sldMk cId="1073319666" sldId="271"/>
            <ac:cxnSpMk id="38" creationId="{C77608D1-8AF5-D3BE-1143-65A8E82CB4F9}"/>
          </ac:cxnSpMkLst>
        </pc:cxnChg>
      </pc:sldChg>
      <pc:sldChg chg="addSp delSp modSp add mod ord">
        <pc:chgData name="Al-Odat, Omar Sami Faleh" userId="00ed9233-b732-4002-afb5-4e27259fd0a0" providerId="ADAL" clId="{41F2318A-0007-4047-87BA-642E6DA488BE}" dt="2024-04-27T01:24:29.824" v="156" actId="1076"/>
        <pc:sldMkLst>
          <pc:docMk/>
          <pc:sldMk cId="4084952707" sldId="272"/>
        </pc:sldMkLst>
        <pc:spChg chg="add mod">
          <ac:chgData name="Al-Odat, Omar Sami Faleh" userId="00ed9233-b732-4002-afb5-4e27259fd0a0" providerId="ADAL" clId="{41F2318A-0007-4047-87BA-642E6DA488BE}" dt="2024-04-24T18:14:08.984" v="78" actId="20577"/>
          <ac:spMkLst>
            <pc:docMk/>
            <pc:sldMk cId="4084952707" sldId="272"/>
            <ac:spMk id="2" creationId="{0DA2E6E6-2481-87B9-90D6-B0736F7DFD1C}"/>
          </ac:spMkLst>
        </pc:spChg>
        <pc:spChg chg="add mod">
          <ac:chgData name="Al-Odat, Omar Sami Faleh" userId="00ed9233-b732-4002-afb5-4e27259fd0a0" providerId="ADAL" clId="{41F2318A-0007-4047-87BA-642E6DA488BE}" dt="2024-04-24T18:14:12.895" v="80" actId="20577"/>
          <ac:spMkLst>
            <pc:docMk/>
            <pc:sldMk cId="4084952707" sldId="272"/>
            <ac:spMk id="4" creationId="{AE8E4A15-2A64-0C7C-F5C4-85A53128408B}"/>
          </ac:spMkLst>
        </pc:spChg>
        <pc:spChg chg="del">
          <ac:chgData name="Al-Odat, Omar Sami Faleh" userId="00ed9233-b732-4002-afb5-4e27259fd0a0" providerId="ADAL" clId="{41F2318A-0007-4047-87BA-642E6DA488BE}" dt="2024-04-24T17:59:06.367" v="5" actId="478"/>
          <ac:spMkLst>
            <pc:docMk/>
            <pc:sldMk cId="4084952707" sldId="272"/>
            <ac:spMk id="9" creationId="{E5AA7A2D-0EAE-96C5-5B7A-D6D5604EDF46}"/>
          </ac:spMkLst>
        </pc:spChg>
        <pc:spChg chg="del">
          <ac:chgData name="Al-Odat, Omar Sami Faleh" userId="00ed9233-b732-4002-afb5-4e27259fd0a0" providerId="ADAL" clId="{41F2318A-0007-4047-87BA-642E6DA488BE}" dt="2024-04-24T17:59:06.367" v="5" actId="478"/>
          <ac:spMkLst>
            <pc:docMk/>
            <pc:sldMk cId="4084952707" sldId="272"/>
            <ac:spMk id="11" creationId="{1EB4ACAB-B60C-AE77-3F2C-14C13D1CE370}"/>
          </ac:spMkLst>
        </pc:spChg>
        <pc:spChg chg="del">
          <ac:chgData name="Al-Odat, Omar Sami Faleh" userId="00ed9233-b732-4002-afb5-4e27259fd0a0" providerId="ADAL" clId="{41F2318A-0007-4047-87BA-642E6DA488BE}" dt="2024-04-24T17:59:06.367" v="5" actId="478"/>
          <ac:spMkLst>
            <pc:docMk/>
            <pc:sldMk cId="4084952707" sldId="272"/>
            <ac:spMk id="12" creationId="{E9E776ED-8215-3D10-EF97-6EBEC535165C}"/>
          </ac:spMkLst>
        </pc:spChg>
        <pc:spChg chg="add del mod">
          <ac:chgData name="Al-Odat, Omar Sami Faleh" userId="00ed9233-b732-4002-afb5-4e27259fd0a0" providerId="ADAL" clId="{41F2318A-0007-4047-87BA-642E6DA488BE}" dt="2024-04-27T01:24:29.824" v="156" actId="1076"/>
          <ac:spMkLst>
            <pc:docMk/>
            <pc:sldMk cId="4084952707" sldId="272"/>
            <ac:spMk id="14" creationId="{26021577-B265-58D5-7438-365B87876AF9}"/>
          </ac:spMkLst>
        </pc:spChg>
        <pc:spChg chg="add del mod">
          <ac:chgData name="Al-Odat, Omar Sami Faleh" userId="00ed9233-b732-4002-afb5-4e27259fd0a0" providerId="ADAL" clId="{41F2318A-0007-4047-87BA-642E6DA488BE}" dt="2024-04-24T18:07:38.492" v="65" actId="20577"/>
          <ac:spMkLst>
            <pc:docMk/>
            <pc:sldMk cId="4084952707" sldId="272"/>
            <ac:spMk id="15" creationId="{7510C961-E30E-72EF-03B1-063E5BE0246D}"/>
          </ac:spMkLst>
        </pc:spChg>
        <pc:spChg chg="add mod">
          <ac:chgData name="Al-Odat, Omar Sami Faleh" userId="00ed9233-b732-4002-afb5-4e27259fd0a0" providerId="ADAL" clId="{41F2318A-0007-4047-87BA-642E6DA488BE}" dt="2024-04-24T18:00:20.121" v="13"/>
          <ac:spMkLst>
            <pc:docMk/>
            <pc:sldMk cId="4084952707" sldId="272"/>
            <ac:spMk id="19" creationId="{38D57DD9-A15D-ECE5-42DD-57AB5C6E9D40}"/>
          </ac:spMkLst>
        </pc:spChg>
        <pc:spChg chg="del">
          <ac:chgData name="Al-Odat, Omar Sami Faleh" userId="00ed9233-b732-4002-afb5-4e27259fd0a0" providerId="ADAL" clId="{41F2318A-0007-4047-87BA-642E6DA488BE}" dt="2024-04-24T17:59:06.367" v="5" actId="478"/>
          <ac:spMkLst>
            <pc:docMk/>
            <pc:sldMk cId="4084952707" sldId="272"/>
            <ac:spMk id="22" creationId="{D36BB31D-2D26-F507-652B-9D039966D581}"/>
          </ac:spMkLst>
        </pc:spChg>
        <pc:spChg chg="mod">
          <ac:chgData name="Al-Odat, Omar Sami Faleh" userId="00ed9233-b732-4002-afb5-4e27259fd0a0" providerId="ADAL" clId="{41F2318A-0007-4047-87BA-642E6DA488BE}" dt="2024-04-24T18:14:01.616" v="75" actId="1076"/>
          <ac:spMkLst>
            <pc:docMk/>
            <pc:sldMk cId="4084952707" sldId="272"/>
            <ac:spMk id="28" creationId="{8CF43914-9E55-A249-B114-0DCB10BC61E6}"/>
          </ac:spMkLst>
        </pc:spChg>
        <pc:spChg chg="mod">
          <ac:chgData name="Al-Odat, Omar Sami Faleh" userId="00ed9233-b732-4002-afb5-4e27259fd0a0" providerId="ADAL" clId="{41F2318A-0007-4047-87BA-642E6DA488BE}" dt="2024-04-24T18:03:09.478" v="55" actId="20577"/>
          <ac:spMkLst>
            <pc:docMk/>
            <pc:sldMk cId="4084952707" sldId="272"/>
            <ac:spMk id="30" creationId="{595D95D5-E62F-2341-82BD-C629058643F6}"/>
          </ac:spMkLst>
        </pc:spChg>
        <pc:spChg chg="mod">
          <ac:chgData name="Al-Odat, Omar Sami Faleh" userId="00ed9233-b732-4002-afb5-4e27259fd0a0" providerId="ADAL" clId="{41F2318A-0007-4047-87BA-642E6DA488BE}" dt="2024-04-27T01:24:25.105" v="155" actId="1076"/>
          <ac:spMkLst>
            <pc:docMk/>
            <pc:sldMk cId="4084952707" sldId="272"/>
            <ac:spMk id="118" creationId="{28E4AB3B-1983-5A11-AF9B-BE6F3A5CCF08}"/>
          </ac:spMkLst>
        </pc:spChg>
        <pc:graphicFrameChg chg="add mod">
          <ac:chgData name="Al-Odat, Omar Sami Faleh" userId="00ed9233-b732-4002-afb5-4e27259fd0a0" providerId="ADAL" clId="{41F2318A-0007-4047-87BA-642E6DA488BE}" dt="2024-04-24T18:00:20.121" v="13"/>
          <ac:graphicFrameMkLst>
            <pc:docMk/>
            <pc:sldMk cId="4084952707" sldId="272"/>
            <ac:graphicFrameMk id="3" creationId="{B8E9A746-C04B-171E-BD82-FCABE6BB4948}"/>
          </ac:graphicFrameMkLst>
        </pc:graphicFrameChg>
        <pc:graphicFrameChg chg="add mod">
          <ac:chgData name="Al-Odat, Omar Sami Faleh" userId="00ed9233-b732-4002-afb5-4e27259fd0a0" providerId="ADAL" clId="{41F2318A-0007-4047-87BA-642E6DA488BE}" dt="2024-04-24T18:00:20.121" v="13"/>
          <ac:graphicFrameMkLst>
            <pc:docMk/>
            <pc:sldMk cId="4084952707" sldId="272"/>
            <ac:graphicFrameMk id="8" creationId="{62F6AB9B-5F25-2A5D-EF58-2E02F2C7CEF3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7:59:06.367" v="5" actId="478"/>
          <ac:graphicFrameMkLst>
            <pc:docMk/>
            <pc:sldMk cId="4084952707" sldId="272"/>
            <ac:graphicFrameMk id="10" creationId="{A34BCB61-4981-8960-35EE-7BD95C67C5B0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7:59:06.367" v="5" actId="478"/>
          <ac:graphicFrameMkLst>
            <pc:docMk/>
            <pc:sldMk cId="4084952707" sldId="272"/>
            <ac:graphicFrameMk id="13" creationId="{CAA7F340-42B2-6AE0-5FB7-0AA4918AF153}"/>
          </ac:graphicFrameMkLst>
        </pc:graphicFrameChg>
        <pc:graphicFrameChg chg="add del mod">
          <ac:chgData name="Al-Odat, Omar Sami Faleh" userId="00ed9233-b732-4002-afb5-4e27259fd0a0" providerId="ADAL" clId="{41F2318A-0007-4047-87BA-642E6DA488BE}" dt="2024-04-24T18:00:32.507" v="14" actId="1076"/>
          <ac:graphicFrameMkLst>
            <pc:docMk/>
            <pc:sldMk cId="4084952707" sldId="272"/>
            <ac:graphicFrameMk id="17" creationId="{DB342948-225C-C919-F012-7CC4179F87BA}"/>
          </ac:graphicFrameMkLst>
        </pc:graphicFrameChg>
        <pc:graphicFrameChg chg="add del mod">
          <ac:chgData name="Al-Odat, Omar Sami Faleh" userId="00ed9233-b732-4002-afb5-4e27259fd0a0" providerId="ADAL" clId="{41F2318A-0007-4047-87BA-642E6DA488BE}" dt="2024-04-24T18:00:32.507" v="14" actId="1076"/>
          <ac:graphicFrameMkLst>
            <pc:docMk/>
            <pc:sldMk cId="4084952707" sldId="272"/>
            <ac:graphicFrameMk id="18" creationId="{54A61834-FF9B-767E-16BC-CB800FD84D5A}"/>
          </ac:graphicFrameMkLst>
        </pc:graphicFrameChg>
        <pc:graphicFrameChg chg="add del mod">
          <ac:chgData name="Al-Odat, Omar Sami Faleh" userId="00ed9233-b732-4002-afb5-4e27259fd0a0" providerId="ADAL" clId="{41F2318A-0007-4047-87BA-642E6DA488BE}" dt="2024-04-24T18:01:04.327" v="29" actId="1038"/>
          <ac:graphicFrameMkLst>
            <pc:docMk/>
            <pc:sldMk cId="4084952707" sldId="272"/>
            <ac:graphicFrameMk id="25" creationId="{5B41EB5B-3D5B-406A-7561-86E514C48F29}"/>
          </ac:graphicFrameMkLst>
        </pc:graphicFrameChg>
        <pc:graphicFrameChg chg="add del mod">
          <ac:chgData name="Al-Odat, Omar Sami Faleh" userId="00ed9233-b732-4002-afb5-4e27259fd0a0" providerId="ADAL" clId="{41F2318A-0007-4047-87BA-642E6DA488BE}" dt="2024-04-24T18:01:04.327" v="29" actId="1038"/>
          <ac:graphicFrameMkLst>
            <pc:docMk/>
            <pc:sldMk cId="4084952707" sldId="272"/>
            <ac:graphicFrameMk id="26" creationId="{C4E0B28B-3808-FAE4-B9E5-6586138E6ACA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7:59:06.367" v="5" actId="478"/>
          <ac:graphicFrameMkLst>
            <pc:docMk/>
            <pc:sldMk cId="4084952707" sldId="272"/>
            <ac:graphicFrameMk id="27" creationId="{A488B49F-94B4-263F-88EE-22F5349171D1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7:59:06.367" v="5" actId="478"/>
          <ac:graphicFrameMkLst>
            <pc:docMk/>
            <pc:sldMk cId="4084952707" sldId="272"/>
            <ac:graphicFrameMk id="29" creationId="{68F26A1C-CD29-5043-19D0-3E9026BF5341}"/>
          </ac:graphicFrameMkLst>
        </pc:graphicFrameChg>
        <pc:picChg chg="add mod">
          <ac:chgData name="Al-Odat, Omar Sami Faleh" userId="00ed9233-b732-4002-afb5-4e27259fd0a0" providerId="ADAL" clId="{41F2318A-0007-4047-87BA-642E6DA488BE}" dt="2024-04-24T18:00:20.121" v="13"/>
          <ac:picMkLst>
            <pc:docMk/>
            <pc:sldMk cId="4084952707" sldId="272"/>
            <ac:picMk id="5" creationId="{44D9A36C-B10E-164D-C77A-736A3271EC83}"/>
          </ac:picMkLst>
        </pc:picChg>
        <pc:picChg chg="add del mod">
          <ac:chgData name="Al-Odat, Omar Sami Faleh" userId="00ed9233-b732-4002-afb5-4e27259fd0a0" providerId="ADAL" clId="{41F2318A-0007-4047-87BA-642E6DA488BE}" dt="2024-04-24T18:14:04.692" v="76" actId="1076"/>
          <ac:picMkLst>
            <pc:docMk/>
            <pc:sldMk cId="4084952707" sldId="272"/>
            <ac:picMk id="6" creationId="{599D8FAB-A9D1-15CE-4DDA-B782FA75AD46}"/>
          </ac:picMkLst>
        </pc:picChg>
        <pc:picChg chg="add del mod">
          <ac:chgData name="Al-Odat, Omar Sami Faleh" userId="00ed9233-b732-4002-afb5-4e27259fd0a0" providerId="ADAL" clId="{41F2318A-0007-4047-87BA-642E6DA488BE}" dt="2024-04-24T18:01:24.257" v="34" actId="14100"/>
          <ac:picMkLst>
            <pc:docMk/>
            <pc:sldMk cId="4084952707" sldId="272"/>
            <ac:picMk id="7" creationId="{3F58AEF9-DB0D-E7F5-EFDF-D9786E221096}"/>
          </ac:picMkLst>
        </pc:picChg>
        <pc:picChg chg="add del mod">
          <ac:chgData name="Al-Odat, Omar Sami Faleh" userId="00ed9233-b732-4002-afb5-4e27259fd0a0" providerId="ADAL" clId="{41F2318A-0007-4047-87BA-642E6DA488BE}" dt="2024-04-24T18:01:17.913" v="33" actId="14100"/>
          <ac:picMkLst>
            <pc:docMk/>
            <pc:sldMk cId="4084952707" sldId="272"/>
            <ac:picMk id="16" creationId="{4083B46A-CE54-E55D-30D5-AB6FD1896CD6}"/>
          </ac:picMkLst>
        </pc:picChg>
        <pc:picChg chg="add mod">
          <ac:chgData name="Al-Odat, Omar Sami Faleh" userId="00ed9233-b732-4002-afb5-4e27259fd0a0" providerId="ADAL" clId="{41F2318A-0007-4047-87BA-642E6DA488BE}" dt="2024-04-24T18:00:20.121" v="13"/>
          <ac:picMkLst>
            <pc:docMk/>
            <pc:sldMk cId="4084952707" sldId="272"/>
            <ac:picMk id="20" creationId="{5969CEE7-C922-BC53-AA7A-883C4FAF2CD9}"/>
          </ac:picMkLst>
        </pc:picChg>
        <pc:picChg chg="del">
          <ac:chgData name="Al-Odat, Omar Sami Faleh" userId="00ed9233-b732-4002-afb5-4e27259fd0a0" providerId="ADAL" clId="{41F2318A-0007-4047-87BA-642E6DA488BE}" dt="2024-04-24T17:59:06.367" v="5" actId="478"/>
          <ac:picMkLst>
            <pc:docMk/>
            <pc:sldMk cId="4084952707" sldId="272"/>
            <ac:picMk id="21" creationId="{BC0CECD4-6AC6-B40B-DFF8-D379D7C72E0A}"/>
          </ac:picMkLst>
        </pc:picChg>
        <pc:picChg chg="del">
          <ac:chgData name="Al-Odat, Omar Sami Faleh" userId="00ed9233-b732-4002-afb5-4e27259fd0a0" providerId="ADAL" clId="{41F2318A-0007-4047-87BA-642E6DA488BE}" dt="2024-04-24T17:59:06.367" v="5" actId="478"/>
          <ac:picMkLst>
            <pc:docMk/>
            <pc:sldMk cId="4084952707" sldId="272"/>
            <ac:picMk id="23" creationId="{DF4A4556-65FF-CB2F-7740-F5F717779D78}"/>
          </ac:picMkLst>
        </pc:picChg>
        <pc:picChg chg="del">
          <ac:chgData name="Al-Odat, Omar Sami Faleh" userId="00ed9233-b732-4002-afb5-4e27259fd0a0" providerId="ADAL" clId="{41F2318A-0007-4047-87BA-642E6DA488BE}" dt="2024-04-24T17:59:06.367" v="5" actId="478"/>
          <ac:picMkLst>
            <pc:docMk/>
            <pc:sldMk cId="4084952707" sldId="272"/>
            <ac:picMk id="24" creationId="{6AAC207B-DD94-5A23-66C4-CC9F48311D19}"/>
          </ac:picMkLst>
        </pc:picChg>
        <pc:picChg chg="add mod">
          <ac:chgData name="Al-Odat, Omar Sami Faleh" userId="00ed9233-b732-4002-afb5-4e27259fd0a0" providerId="ADAL" clId="{41F2318A-0007-4047-87BA-642E6DA488BE}" dt="2024-04-24T18:00:20.121" v="13"/>
          <ac:picMkLst>
            <pc:docMk/>
            <pc:sldMk cId="4084952707" sldId="272"/>
            <ac:picMk id="50" creationId="{83A671E6-538E-07CB-2076-4E1508D23D6F}"/>
          </ac:picMkLst>
        </pc:picChg>
      </pc:sldChg>
      <pc:sldChg chg="delSp add del mod">
        <pc:chgData name="Al-Odat, Omar Sami Faleh" userId="00ed9233-b732-4002-afb5-4e27259fd0a0" providerId="ADAL" clId="{41F2318A-0007-4047-87BA-642E6DA488BE}" dt="2024-04-24T18:03:02.298" v="53" actId="47"/>
        <pc:sldMkLst>
          <pc:docMk/>
          <pc:sldMk cId="3237188094" sldId="299"/>
        </pc:sldMkLst>
        <pc:spChg chg="del">
          <ac:chgData name="Al-Odat, Omar Sami Faleh" userId="00ed9233-b732-4002-afb5-4e27259fd0a0" providerId="ADAL" clId="{41F2318A-0007-4047-87BA-642E6DA488BE}" dt="2024-04-24T18:00:17.704" v="12" actId="21"/>
          <ac:spMkLst>
            <pc:docMk/>
            <pc:sldMk cId="3237188094" sldId="299"/>
            <ac:spMk id="2" creationId="{0DA2E6E6-2481-87B9-90D6-B0736F7DFD1C}"/>
          </ac:spMkLst>
        </pc:spChg>
        <pc:spChg chg="del">
          <ac:chgData name="Al-Odat, Omar Sami Faleh" userId="00ed9233-b732-4002-afb5-4e27259fd0a0" providerId="ADAL" clId="{41F2318A-0007-4047-87BA-642E6DA488BE}" dt="2024-04-24T18:01:59.613" v="37" actId="21"/>
          <ac:spMkLst>
            <pc:docMk/>
            <pc:sldMk cId="3237188094" sldId="299"/>
            <ac:spMk id="5" creationId="{B7385783-D12A-B85D-E132-3C6ED3B3447F}"/>
          </ac:spMkLst>
        </pc:spChg>
        <pc:spChg chg="del">
          <ac:chgData name="Al-Odat, Omar Sami Faleh" userId="00ed9233-b732-4002-afb5-4e27259fd0a0" providerId="ADAL" clId="{41F2318A-0007-4047-87BA-642E6DA488BE}" dt="2024-04-24T18:01:59.613" v="37" actId="21"/>
          <ac:spMkLst>
            <pc:docMk/>
            <pc:sldMk cId="3237188094" sldId="299"/>
            <ac:spMk id="6" creationId="{9C4FD6E7-F27F-8181-D5CE-80DEE3ADB98B}"/>
          </ac:spMkLst>
        </pc:spChg>
        <pc:spChg chg="del">
          <ac:chgData name="Al-Odat, Omar Sami Faleh" userId="00ed9233-b732-4002-afb5-4e27259fd0a0" providerId="ADAL" clId="{41F2318A-0007-4047-87BA-642E6DA488BE}" dt="2024-04-24T18:01:59.613" v="37" actId="21"/>
          <ac:spMkLst>
            <pc:docMk/>
            <pc:sldMk cId="3237188094" sldId="299"/>
            <ac:spMk id="15" creationId="{321F2EA4-BA93-1393-693A-945A080DFD00}"/>
          </ac:spMkLst>
        </pc:spChg>
        <pc:spChg chg="del">
          <ac:chgData name="Al-Odat, Omar Sami Faleh" userId="00ed9233-b732-4002-afb5-4e27259fd0a0" providerId="ADAL" clId="{41F2318A-0007-4047-87BA-642E6DA488BE}" dt="2024-04-24T18:00:17.704" v="12" actId="21"/>
          <ac:spMkLst>
            <pc:docMk/>
            <pc:sldMk cId="3237188094" sldId="299"/>
            <ac:spMk id="19" creationId="{38D57DD9-A15D-ECE5-42DD-57AB5C6E9D40}"/>
          </ac:spMkLst>
        </pc:spChg>
        <pc:spChg chg="del">
          <ac:chgData name="Al-Odat, Omar Sami Faleh" userId="00ed9233-b732-4002-afb5-4e27259fd0a0" providerId="ADAL" clId="{41F2318A-0007-4047-87BA-642E6DA488BE}" dt="2024-04-24T18:00:17.704" v="12" actId="21"/>
          <ac:spMkLst>
            <pc:docMk/>
            <pc:sldMk cId="3237188094" sldId="299"/>
            <ac:spMk id="118" creationId="{AE8E4A15-2A64-0C7C-F5C4-85A53128408B}"/>
          </ac:spMkLst>
        </pc:spChg>
        <pc:graphicFrameChg chg="del">
          <ac:chgData name="Al-Odat, Omar Sami Faleh" userId="00ed9233-b732-4002-afb5-4e27259fd0a0" providerId="ADAL" clId="{41F2318A-0007-4047-87BA-642E6DA488BE}" dt="2024-04-24T18:00:17.704" v="12" actId="21"/>
          <ac:graphicFrameMkLst>
            <pc:docMk/>
            <pc:sldMk cId="3237188094" sldId="299"/>
            <ac:graphicFrameMk id="7" creationId="{62F6AB9B-5F25-2A5D-EF58-2E02F2C7CEF3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8:01:59.613" v="37" actId="21"/>
          <ac:graphicFrameMkLst>
            <pc:docMk/>
            <pc:sldMk cId="3237188094" sldId="299"/>
            <ac:graphicFrameMk id="18" creationId="{FC30E3A6-1460-2F02-D72C-007610C659F1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8:01:59.613" v="37" actId="21"/>
          <ac:graphicFrameMkLst>
            <pc:docMk/>
            <pc:sldMk cId="3237188094" sldId="299"/>
            <ac:graphicFrameMk id="22" creationId="{16B8C8CA-4AEC-002D-BFD1-FC16FDB2B1E4}"/>
          </ac:graphicFrameMkLst>
        </pc:graphicFrameChg>
        <pc:graphicFrameChg chg="del">
          <ac:chgData name="Al-Odat, Omar Sami Faleh" userId="00ed9233-b732-4002-afb5-4e27259fd0a0" providerId="ADAL" clId="{41F2318A-0007-4047-87BA-642E6DA488BE}" dt="2024-04-24T18:00:17.704" v="12" actId="21"/>
          <ac:graphicFrameMkLst>
            <pc:docMk/>
            <pc:sldMk cId="3237188094" sldId="299"/>
            <ac:graphicFrameMk id="29" creationId="{B8E9A746-C04B-171E-BD82-FCABE6BB4948}"/>
          </ac:graphicFrameMkLst>
        </pc:graphicFrameChg>
        <pc:picChg chg="del">
          <ac:chgData name="Al-Odat, Omar Sami Faleh" userId="00ed9233-b732-4002-afb5-4e27259fd0a0" providerId="ADAL" clId="{41F2318A-0007-4047-87BA-642E6DA488BE}" dt="2024-04-24T18:00:17.704" v="12" actId="21"/>
          <ac:picMkLst>
            <pc:docMk/>
            <pc:sldMk cId="3237188094" sldId="299"/>
            <ac:picMk id="12" creationId="{44D9A36C-B10E-164D-C77A-736A3271EC83}"/>
          </ac:picMkLst>
        </pc:picChg>
        <pc:picChg chg="del">
          <ac:chgData name="Al-Odat, Omar Sami Faleh" userId="00ed9233-b732-4002-afb5-4e27259fd0a0" providerId="ADAL" clId="{41F2318A-0007-4047-87BA-642E6DA488BE}" dt="2024-04-24T18:00:17.704" v="12" actId="21"/>
          <ac:picMkLst>
            <pc:docMk/>
            <pc:sldMk cId="3237188094" sldId="299"/>
            <ac:picMk id="25" creationId="{5969CEE7-C922-BC53-AA7A-883C4FAF2CD9}"/>
          </ac:picMkLst>
        </pc:picChg>
        <pc:picChg chg="del">
          <ac:chgData name="Al-Odat, Omar Sami Faleh" userId="00ed9233-b732-4002-afb5-4e27259fd0a0" providerId="ADAL" clId="{41F2318A-0007-4047-87BA-642E6DA488BE}" dt="2024-04-24T18:00:17.704" v="12" actId="21"/>
          <ac:picMkLst>
            <pc:docMk/>
            <pc:sldMk cId="3237188094" sldId="299"/>
            <ac:picMk id="50" creationId="{83A671E6-538E-07CB-2076-4E1508D23D6F}"/>
          </ac:picMkLst>
        </pc:picChg>
        <pc:picChg chg="del">
          <ac:chgData name="Al-Odat, Omar Sami Faleh" userId="00ed9233-b732-4002-afb5-4e27259fd0a0" providerId="ADAL" clId="{41F2318A-0007-4047-87BA-642E6DA488BE}" dt="2024-04-24T18:01:59.613" v="37" actId="21"/>
          <ac:picMkLst>
            <pc:docMk/>
            <pc:sldMk cId="3237188094" sldId="299"/>
            <ac:picMk id="54" creationId="{DE2A454F-3995-56E1-25FA-A133EABD3482}"/>
          </ac:picMkLst>
        </pc:picChg>
        <pc:picChg chg="del">
          <ac:chgData name="Al-Odat, Omar Sami Faleh" userId="00ed9233-b732-4002-afb5-4e27259fd0a0" providerId="ADAL" clId="{41F2318A-0007-4047-87BA-642E6DA488BE}" dt="2024-04-24T18:01:59.613" v="37" actId="21"/>
          <ac:picMkLst>
            <pc:docMk/>
            <pc:sldMk cId="3237188094" sldId="299"/>
            <ac:picMk id="67" creationId="{6E860B93-428D-11CD-5FAB-F6C0B8BA2E8C}"/>
          </ac:picMkLst>
        </pc:picChg>
        <pc:picChg chg="del">
          <ac:chgData name="Al-Odat, Omar Sami Faleh" userId="00ed9233-b732-4002-afb5-4e27259fd0a0" providerId="ADAL" clId="{41F2318A-0007-4047-87BA-642E6DA488BE}" dt="2024-04-24T18:01:59.613" v="37" actId="21"/>
          <ac:picMkLst>
            <pc:docMk/>
            <pc:sldMk cId="3237188094" sldId="299"/>
            <ac:picMk id="86" creationId="{2A883C78-F696-5E02-3CEF-7C43449C2B64}"/>
          </ac:picMkLst>
        </pc:picChg>
      </pc:sldChg>
    </pc:docChg>
  </pc:docChgLst>
  <pc:docChgLst>
    <pc:chgData name="Al-Odat, Omar Sami Faleh" userId="00ed9233-b732-4002-afb5-4e27259fd0a0" providerId="ADAL" clId="{B1C704AE-D5E0-4E68-AD40-1EC0A2669F77}"/>
    <pc:docChg chg="modSld">
      <pc:chgData name="Al-Odat, Omar Sami Faleh" userId="00ed9233-b732-4002-afb5-4e27259fd0a0" providerId="ADAL" clId="{B1C704AE-D5E0-4E68-AD40-1EC0A2669F77}" dt="2024-07-21T20:53:49.968" v="44"/>
      <pc:docMkLst>
        <pc:docMk/>
      </pc:docMkLst>
      <pc:sldChg chg="modSp">
        <pc:chgData name="Al-Odat, Omar Sami Faleh" userId="00ed9233-b732-4002-afb5-4e27259fd0a0" providerId="ADAL" clId="{B1C704AE-D5E0-4E68-AD40-1EC0A2669F77}" dt="2024-07-21T20:33:59.627" v="6"/>
        <pc:sldMkLst>
          <pc:docMk/>
          <pc:sldMk cId="2573125304" sldId="256"/>
        </pc:sldMkLst>
        <pc:graphicFrameChg chg="mod">
          <ac:chgData name="Al-Odat, Omar Sami Faleh" userId="00ed9233-b732-4002-afb5-4e27259fd0a0" providerId="ADAL" clId="{B1C704AE-D5E0-4E68-AD40-1EC0A2669F77}" dt="2024-07-21T20:33:32.323" v="3"/>
          <ac:graphicFrameMkLst>
            <pc:docMk/>
            <pc:sldMk cId="2573125304" sldId="256"/>
            <ac:graphicFrameMk id="7" creationId="{9DD1641A-C8DD-6FFC-BA29-20F395B181C8}"/>
          </ac:graphicFrameMkLst>
        </pc:graphicFrameChg>
        <pc:graphicFrameChg chg="mod">
          <ac:chgData name="Al-Odat, Omar Sami Faleh" userId="00ed9233-b732-4002-afb5-4e27259fd0a0" providerId="ADAL" clId="{B1C704AE-D5E0-4E68-AD40-1EC0A2669F77}" dt="2024-07-21T20:33:59.627" v="6"/>
          <ac:graphicFrameMkLst>
            <pc:docMk/>
            <pc:sldMk cId="2573125304" sldId="256"/>
            <ac:graphicFrameMk id="8" creationId="{1501DEF2-CD84-6C21-C031-E1E0343AB50E}"/>
          </ac:graphicFrameMkLst>
        </pc:graphicFrameChg>
      </pc:sldChg>
      <pc:sldChg chg="modSp">
        <pc:chgData name="Al-Odat, Omar Sami Faleh" userId="00ed9233-b732-4002-afb5-4e27259fd0a0" providerId="ADAL" clId="{B1C704AE-D5E0-4E68-AD40-1EC0A2669F77}" dt="2024-07-21T20:53:49.968" v="44"/>
        <pc:sldMkLst>
          <pc:docMk/>
          <pc:sldMk cId="2971561120" sldId="264"/>
        </pc:sldMkLst>
        <pc:graphicFrameChg chg="mod">
          <ac:chgData name="Al-Odat, Omar Sami Faleh" userId="00ed9233-b732-4002-afb5-4e27259fd0a0" providerId="ADAL" clId="{B1C704AE-D5E0-4E68-AD40-1EC0A2669F77}" dt="2024-07-21T20:51:50.474" v="32"/>
          <ac:graphicFrameMkLst>
            <pc:docMk/>
            <pc:sldMk cId="2971561120" sldId="264"/>
            <ac:graphicFrameMk id="4" creationId="{FC30E3A6-1460-2F02-D72C-007610C659F1}"/>
          </ac:graphicFrameMkLst>
        </pc:graphicFrameChg>
        <pc:graphicFrameChg chg="mod">
          <ac:chgData name="Al-Odat, Omar Sami Faleh" userId="00ed9233-b732-4002-afb5-4e27259fd0a0" providerId="ADAL" clId="{B1C704AE-D5E0-4E68-AD40-1EC0A2669F77}" dt="2024-07-21T20:52:27.518" v="36"/>
          <ac:graphicFrameMkLst>
            <pc:docMk/>
            <pc:sldMk cId="2971561120" sldId="264"/>
            <ac:graphicFrameMk id="8" creationId="{16B8C8CA-4AEC-002D-BFD1-FC16FDB2B1E4}"/>
          </ac:graphicFrameMkLst>
        </pc:graphicFrameChg>
        <pc:graphicFrameChg chg="mod">
          <ac:chgData name="Al-Odat, Omar Sami Faleh" userId="00ed9233-b732-4002-afb5-4e27259fd0a0" providerId="ADAL" clId="{B1C704AE-D5E0-4E68-AD40-1EC0A2669F77}" dt="2024-07-21T20:53:19.142" v="40"/>
          <ac:graphicFrameMkLst>
            <pc:docMk/>
            <pc:sldMk cId="2971561120" sldId="264"/>
            <ac:graphicFrameMk id="27" creationId="{A488B49F-94B4-263F-88EE-22F5349171D1}"/>
          </ac:graphicFrameMkLst>
        </pc:graphicFrameChg>
        <pc:graphicFrameChg chg="mod">
          <ac:chgData name="Al-Odat, Omar Sami Faleh" userId="00ed9233-b732-4002-afb5-4e27259fd0a0" providerId="ADAL" clId="{B1C704AE-D5E0-4E68-AD40-1EC0A2669F77}" dt="2024-07-21T20:53:49.968" v="44"/>
          <ac:graphicFrameMkLst>
            <pc:docMk/>
            <pc:sldMk cId="2971561120" sldId="264"/>
            <ac:graphicFrameMk id="29" creationId="{68F26A1C-CD29-5043-19D0-3E9026BF5341}"/>
          </ac:graphicFrameMkLst>
        </pc:graphicFrameChg>
      </pc:sldChg>
      <pc:sldChg chg="modSp">
        <pc:chgData name="Al-Odat, Omar Sami Faleh" userId="00ed9233-b732-4002-afb5-4e27259fd0a0" providerId="ADAL" clId="{B1C704AE-D5E0-4E68-AD40-1EC0A2669F77}" dt="2024-07-21T20:36:10.074" v="14"/>
        <pc:sldMkLst>
          <pc:docMk/>
          <pc:sldMk cId="1073319666" sldId="271"/>
        </pc:sldMkLst>
        <pc:graphicFrameChg chg="mod">
          <ac:chgData name="Al-Odat, Omar Sami Faleh" userId="00ed9233-b732-4002-afb5-4e27259fd0a0" providerId="ADAL" clId="{B1C704AE-D5E0-4E68-AD40-1EC0A2669F77}" dt="2024-07-21T20:36:10.074" v="14"/>
          <ac:graphicFrameMkLst>
            <pc:docMk/>
            <pc:sldMk cId="1073319666" sldId="271"/>
            <ac:graphicFrameMk id="6" creationId="{68DB6CF2-6E3D-E55F-4D14-38CA22FE7645}"/>
          </ac:graphicFrameMkLst>
        </pc:graphicFrameChg>
        <pc:graphicFrameChg chg="mod">
          <ac:chgData name="Al-Odat, Omar Sami Faleh" userId="00ed9233-b732-4002-afb5-4e27259fd0a0" providerId="ADAL" clId="{B1C704AE-D5E0-4E68-AD40-1EC0A2669F77}" dt="2024-07-21T20:34:37.545" v="10"/>
          <ac:graphicFrameMkLst>
            <pc:docMk/>
            <pc:sldMk cId="1073319666" sldId="271"/>
            <ac:graphicFrameMk id="14" creationId="{E2646627-0532-25E2-BEB6-0CC5308D15E5}"/>
          </ac:graphicFrameMkLst>
        </pc:graphicFrameChg>
      </pc:sldChg>
      <pc:sldChg chg="modSp">
        <pc:chgData name="Al-Odat, Omar Sami Faleh" userId="00ed9233-b732-4002-afb5-4e27259fd0a0" providerId="ADAL" clId="{B1C704AE-D5E0-4E68-AD40-1EC0A2669F77}" dt="2024-07-21T20:39:36.738" v="29"/>
        <pc:sldMkLst>
          <pc:docMk/>
          <pc:sldMk cId="4084952707" sldId="272"/>
        </pc:sldMkLst>
        <pc:graphicFrameChg chg="mod">
          <ac:chgData name="Al-Odat, Omar Sami Faleh" userId="00ed9233-b732-4002-afb5-4e27259fd0a0" providerId="ADAL" clId="{B1C704AE-D5E0-4E68-AD40-1EC0A2669F77}" dt="2024-07-21T20:36:44.989" v="19"/>
          <ac:graphicFrameMkLst>
            <pc:docMk/>
            <pc:sldMk cId="4084952707" sldId="272"/>
            <ac:graphicFrameMk id="3" creationId="{B8E9A746-C04B-171E-BD82-FCABE6BB4948}"/>
          </ac:graphicFrameMkLst>
        </pc:graphicFrameChg>
        <pc:graphicFrameChg chg="mod">
          <ac:chgData name="Al-Odat, Omar Sami Faleh" userId="00ed9233-b732-4002-afb5-4e27259fd0a0" providerId="ADAL" clId="{B1C704AE-D5E0-4E68-AD40-1EC0A2669F77}" dt="2024-07-21T20:37:21.337" v="23"/>
          <ac:graphicFrameMkLst>
            <pc:docMk/>
            <pc:sldMk cId="4084952707" sldId="272"/>
            <ac:graphicFrameMk id="8" creationId="{62F6AB9B-5F25-2A5D-EF58-2E02F2C7CEF3}"/>
          </ac:graphicFrameMkLst>
        </pc:graphicFrameChg>
        <pc:graphicFrameChg chg="mod">
          <ac:chgData name="Al-Odat, Omar Sami Faleh" userId="00ed9233-b732-4002-afb5-4e27259fd0a0" providerId="ADAL" clId="{B1C704AE-D5E0-4E68-AD40-1EC0A2669F77}" dt="2024-07-21T20:38:36.613" v="26"/>
          <ac:graphicFrameMkLst>
            <pc:docMk/>
            <pc:sldMk cId="4084952707" sldId="272"/>
            <ac:graphicFrameMk id="25" creationId="{5B41EB5B-3D5B-406A-7561-86E514C48F29}"/>
          </ac:graphicFrameMkLst>
        </pc:graphicFrameChg>
        <pc:graphicFrameChg chg="mod">
          <ac:chgData name="Al-Odat, Omar Sami Faleh" userId="00ed9233-b732-4002-afb5-4e27259fd0a0" providerId="ADAL" clId="{B1C704AE-D5E0-4E68-AD40-1EC0A2669F77}" dt="2024-07-21T20:39:36.738" v="29"/>
          <ac:graphicFrameMkLst>
            <pc:docMk/>
            <pc:sldMk cId="4084952707" sldId="272"/>
            <ac:graphicFrameMk id="26" creationId="{C4E0B28B-3808-FAE4-B9E5-6586138E6ACA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972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1344" y="1"/>
            <a:ext cx="3037840" cy="466972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88FB1AC-0445-6A44-BCDF-67CE7B3D2270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4"/>
            <a:ext cx="5608320" cy="3660456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429"/>
            <a:ext cx="3037840" cy="466971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1344" y="8829429"/>
            <a:ext cx="3037840" cy="466971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54D7AF91-E7DD-4845-A944-BC5E050411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368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D7AF91-E7DD-4845-A944-BC5E0504118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614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D7AF91-E7DD-4845-A944-BC5E0504118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5954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D7AF91-E7DD-4845-A944-BC5E0504118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087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D7AF91-E7DD-4845-A944-BC5E0504118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3185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D7AF91-E7DD-4845-A944-BC5E0504118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2274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2" indent="0" algn="ctr">
              <a:buNone/>
              <a:defRPr sz="1500"/>
            </a:lvl2pPr>
            <a:lvl3pPr marL="685783" indent="0" algn="ctr">
              <a:buNone/>
              <a:defRPr sz="1350"/>
            </a:lvl3pPr>
            <a:lvl4pPr marL="1028675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8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2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46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90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69445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12615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695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640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566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358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479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117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8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897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8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8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165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8/23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B21873-43B6-6E49-917F-A05FDB822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521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11" Type="http://schemas.openxmlformats.org/officeDocument/2006/relationships/oleObject" Target="../embeddings/oleObject2.bin"/><Relationship Id="rId5" Type="http://schemas.openxmlformats.org/officeDocument/2006/relationships/image" Target="../media/image3.png"/><Relationship Id="rId10" Type="http://schemas.openxmlformats.org/officeDocument/2006/relationships/image" Target="../media/image7.emf"/><Relationship Id="rId4" Type="http://schemas.openxmlformats.org/officeDocument/2006/relationships/image" Target="../media/image2.png"/><Relationship Id="rId9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image" Target="../media/image9.png"/><Relationship Id="rId7" Type="http://schemas.openxmlformats.org/officeDocument/2006/relationships/image" Target="../media/image11.emf"/><Relationship Id="rId12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13.emf"/><Relationship Id="rId5" Type="http://schemas.openxmlformats.org/officeDocument/2006/relationships/image" Target="../media/image10.emf"/><Relationship Id="rId10" Type="http://schemas.openxmlformats.org/officeDocument/2006/relationships/oleObject" Target="../embeddings/oleObject6.bin"/><Relationship Id="rId4" Type="http://schemas.openxmlformats.org/officeDocument/2006/relationships/oleObject" Target="../embeddings/oleObject3.bin"/><Relationship Id="rId9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oleObject" Target="../embeddings/oleObject10.bin"/><Relationship Id="rId18" Type="http://schemas.openxmlformats.org/officeDocument/2006/relationships/image" Target="../media/image24.png"/><Relationship Id="rId3" Type="http://schemas.openxmlformats.org/officeDocument/2006/relationships/notesSlide" Target="../notesSlides/notesSlide3.xml"/><Relationship Id="rId21" Type="http://schemas.openxmlformats.org/officeDocument/2006/relationships/image" Target="../media/image26.png"/><Relationship Id="rId7" Type="http://schemas.openxmlformats.org/officeDocument/2006/relationships/image" Target="../media/image16.emf"/><Relationship Id="rId12" Type="http://schemas.openxmlformats.org/officeDocument/2006/relationships/image" Target="../media/image20.emf"/><Relationship Id="rId17" Type="http://schemas.openxmlformats.org/officeDocument/2006/relationships/image" Target="../media/image23.png"/><Relationship Id="rId2" Type="http://schemas.openxmlformats.org/officeDocument/2006/relationships/slideLayout" Target="../slideLayouts/slideLayout12.xml"/><Relationship Id="rId16" Type="http://schemas.openxmlformats.org/officeDocument/2006/relationships/image" Target="../media/image22.emf"/><Relationship Id="rId20" Type="http://schemas.openxmlformats.org/officeDocument/2006/relationships/image" Target="../media/image25.emf"/><Relationship Id="rId1" Type="http://schemas.openxmlformats.org/officeDocument/2006/relationships/themeOverride" Target="../theme/themeOverride1.xml"/><Relationship Id="rId6" Type="http://schemas.openxmlformats.org/officeDocument/2006/relationships/oleObject" Target="../embeddings/oleObject8.bin"/><Relationship Id="rId11" Type="http://schemas.openxmlformats.org/officeDocument/2006/relationships/oleObject" Target="../embeddings/oleObject9.bin"/><Relationship Id="rId5" Type="http://schemas.openxmlformats.org/officeDocument/2006/relationships/image" Target="../media/image15.emf"/><Relationship Id="rId15" Type="http://schemas.openxmlformats.org/officeDocument/2006/relationships/oleObject" Target="../embeddings/oleObject11.bin"/><Relationship Id="rId10" Type="http://schemas.openxmlformats.org/officeDocument/2006/relationships/image" Target="../media/image19.png"/><Relationship Id="rId19" Type="http://schemas.openxmlformats.org/officeDocument/2006/relationships/oleObject" Target="../embeddings/oleObject12.bin"/><Relationship Id="rId4" Type="http://schemas.openxmlformats.org/officeDocument/2006/relationships/oleObject" Target="../embeddings/oleObject7.bin"/><Relationship Id="rId9" Type="http://schemas.openxmlformats.org/officeDocument/2006/relationships/image" Target="../media/image18.png"/><Relationship Id="rId14" Type="http://schemas.openxmlformats.org/officeDocument/2006/relationships/image" Target="../media/image2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oleObject" Target="../embeddings/oleObject16.bin"/><Relationship Id="rId18" Type="http://schemas.openxmlformats.org/officeDocument/2006/relationships/image" Target="../media/image35.emf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38.png"/><Relationship Id="rId7" Type="http://schemas.openxmlformats.org/officeDocument/2006/relationships/image" Target="../media/image28.emf"/><Relationship Id="rId12" Type="http://schemas.openxmlformats.org/officeDocument/2006/relationships/image" Target="../media/image32.emf"/><Relationship Id="rId17" Type="http://schemas.openxmlformats.org/officeDocument/2006/relationships/oleObject" Target="../embeddings/oleObject18.bin"/><Relationship Id="rId2" Type="http://schemas.openxmlformats.org/officeDocument/2006/relationships/slideLayout" Target="../slideLayouts/slideLayout12.xml"/><Relationship Id="rId16" Type="http://schemas.openxmlformats.org/officeDocument/2006/relationships/image" Target="../media/image34.emf"/><Relationship Id="rId20" Type="http://schemas.openxmlformats.org/officeDocument/2006/relationships/image" Target="../media/image37.png"/><Relationship Id="rId1" Type="http://schemas.openxmlformats.org/officeDocument/2006/relationships/themeOverride" Target="../theme/themeOverride2.xml"/><Relationship Id="rId6" Type="http://schemas.openxmlformats.org/officeDocument/2006/relationships/oleObject" Target="../embeddings/oleObject14.bin"/><Relationship Id="rId11" Type="http://schemas.openxmlformats.org/officeDocument/2006/relationships/oleObject" Target="../embeddings/oleObject15.bin"/><Relationship Id="rId5" Type="http://schemas.openxmlformats.org/officeDocument/2006/relationships/image" Target="../media/image27.emf"/><Relationship Id="rId15" Type="http://schemas.openxmlformats.org/officeDocument/2006/relationships/oleObject" Target="../embeddings/oleObject17.bin"/><Relationship Id="rId10" Type="http://schemas.openxmlformats.org/officeDocument/2006/relationships/image" Target="../media/image31.png"/><Relationship Id="rId19" Type="http://schemas.openxmlformats.org/officeDocument/2006/relationships/image" Target="../media/image36.png"/><Relationship Id="rId4" Type="http://schemas.openxmlformats.org/officeDocument/2006/relationships/oleObject" Target="../embeddings/oleObject13.bin"/><Relationship Id="rId9" Type="http://schemas.openxmlformats.org/officeDocument/2006/relationships/image" Target="../media/image30.png"/><Relationship Id="rId14" Type="http://schemas.openxmlformats.org/officeDocument/2006/relationships/image" Target="../media/image3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13" Type="http://schemas.openxmlformats.org/officeDocument/2006/relationships/image" Target="../media/image45.png"/><Relationship Id="rId3" Type="http://schemas.openxmlformats.org/officeDocument/2006/relationships/notesSlide" Target="../notesSlides/notesSlide5.xml"/><Relationship Id="rId7" Type="http://schemas.openxmlformats.org/officeDocument/2006/relationships/oleObject" Target="../embeddings/oleObject20.bin"/><Relationship Id="rId12" Type="http://schemas.openxmlformats.org/officeDocument/2006/relationships/image" Target="../media/image44.png"/><Relationship Id="rId2" Type="http://schemas.openxmlformats.org/officeDocument/2006/relationships/slideLayout" Target="../slideLayouts/slideLayout12.xml"/><Relationship Id="rId1" Type="http://schemas.openxmlformats.org/officeDocument/2006/relationships/themeOverride" Target="../theme/themeOverride3.xml"/><Relationship Id="rId6" Type="http://schemas.openxmlformats.org/officeDocument/2006/relationships/image" Target="../media/image40.emf"/><Relationship Id="rId11" Type="http://schemas.openxmlformats.org/officeDocument/2006/relationships/image" Target="../media/image43.png"/><Relationship Id="rId5" Type="http://schemas.openxmlformats.org/officeDocument/2006/relationships/oleObject" Target="../embeddings/oleObject19.bin"/><Relationship Id="rId10" Type="http://schemas.openxmlformats.org/officeDocument/2006/relationships/image" Target="../media/image42.emf"/><Relationship Id="rId4" Type="http://schemas.openxmlformats.org/officeDocument/2006/relationships/image" Target="../media/image39.png"/><Relationship Id="rId9" Type="http://schemas.openxmlformats.org/officeDocument/2006/relationships/oleObject" Target="../embeddings/oleObject21.bin"/><Relationship Id="rId14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18;p1">
            <a:extLst>
              <a:ext uri="{FF2B5EF4-FFF2-40B4-BE49-F238E27FC236}">
                <a16:creationId xmlns:a16="http://schemas.microsoft.com/office/drawing/2014/main" id="{2E47B640-00C0-DA43-9729-E51993B946DB}"/>
              </a:ext>
            </a:extLst>
          </p:cNvPr>
          <p:cNvSpPr txBox="1"/>
          <p:nvPr/>
        </p:nvSpPr>
        <p:spPr>
          <a:xfrm>
            <a:off x="4641448" y="-40390"/>
            <a:ext cx="2377154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1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" name="Google Shape;91;p1">
            <a:extLst>
              <a:ext uri="{FF2B5EF4-FFF2-40B4-BE49-F238E27FC236}">
                <a16:creationId xmlns:a16="http://schemas.microsoft.com/office/drawing/2014/main" id="{7D1E10CE-0792-754D-AA11-43242EB93C17}"/>
              </a:ext>
            </a:extLst>
          </p:cNvPr>
          <p:cNvSpPr txBox="1"/>
          <p:nvPr/>
        </p:nvSpPr>
        <p:spPr>
          <a:xfrm>
            <a:off x="1233996" y="1481079"/>
            <a:ext cx="324349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" name="Google Shape;143;p3">
            <a:extLst>
              <a:ext uri="{FF2B5EF4-FFF2-40B4-BE49-F238E27FC236}">
                <a16:creationId xmlns:a16="http://schemas.microsoft.com/office/drawing/2014/main" id="{ED6E3338-5552-6C31-7A97-33DFA91C269E}"/>
              </a:ext>
            </a:extLst>
          </p:cNvPr>
          <p:cNvSpPr txBox="1"/>
          <p:nvPr/>
        </p:nvSpPr>
        <p:spPr>
          <a:xfrm>
            <a:off x="3504763" y="1460003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6" name="Google Shape;143;p3">
            <a:extLst>
              <a:ext uri="{FF2B5EF4-FFF2-40B4-BE49-F238E27FC236}">
                <a16:creationId xmlns:a16="http://schemas.microsoft.com/office/drawing/2014/main" id="{4D99BF2C-5B8A-A556-EB06-7C04F39FA91E}"/>
              </a:ext>
            </a:extLst>
          </p:cNvPr>
          <p:cNvSpPr txBox="1"/>
          <p:nvPr/>
        </p:nvSpPr>
        <p:spPr>
          <a:xfrm>
            <a:off x="3504764" y="3135833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Google Shape;143;p3">
            <a:extLst>
              <a:ext uri="{FF2B5EF4-FFF2-40B4-BE49-F238E27FC236}">
                <a16:creationId xmlns:a16="http://schemas.microsoft.com/office/drawing/2014/main" id="{3F9F24FD-EC4B-1280-6845-198FD6713D0C}"/>
              </a:ext>
            </a:extLst>
          </p:cNvPr>
          <p:cNvSpPr txBox="1"/>
          <p:nvPr/>
        </p:nvSpPr>
        <p:spPr>
          <a:xfrm>
            <a:off x="1242601" y="4522309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" name="Google Shape;143;p3">
            <a:extLst>
              <a:ext uri="{FF2B5EF4-FFF2-40B4-BE49-F238E27FC236}">
                <a16:creationId xmlns:a16="http://schemas.microsoft.com/office/drawing/2014/main" id="{B2501EDE-77B0-382A-B3F5-DD939A5497E5}"/>
              </a:ext>
            </a:extLst>
          </p:cNvPr>
          <p:cNvSpPr txBox="1"/>
          <p:nvPr/>
        </p:nvSpPr>
        <p:spPr>
          <a:xfrm>
            <a:off x="3504765" y="4487382"/>
            <a:ext cx="306593" cy="3929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	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" name="Picture 4" descr="A picture containing text, vector graphics&#10;&#10;Description automatically generated">
            <a:extLst>
              <a:ext uri="{FF2B5EF4-FFF2-40B4-BE49-F238E27FC236}">
                <a16:creationId xmlns:a16="http://schemas.microsoft.com/office/drawing/2014/main" id="{A8417784-59E5-9C1B-152C-33E716D3D7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11"/>
          <a:stretch/>
        </p:blipFill>
        <p:spPr>
          <a:xfrm>
            <a:off x="1458189" y="1600620"/>
            <a:ext cx="1863800" cy="1696249"/>
          </a:xfrm>
          <a:prstGeom prst="rect">
            <a:avLst/>
          </a:prstGeom>
        </p:spPr>
      </p:pic>
      <p:sp>
        <p:nvSpPr>
          <p:cNvPr id="12" name="Google Shape;91;p1">
            <a:extLst>
              <a:ext uri="{FF2B5EF4-FFF2-40B4-BE49-F238E27FC236}">
                <a16:creationId xmlns:a16="http://schemas.microsoft.com/office/drawing/2014/main" id="{5EE4ECA9-C836-9A6F-ACA6-B460E10E835F}"/>
              </a:ext>
            </a:extLst>
          </p:cNvPr>
          <p:cNvSpPr txBox="1"/>
          <p:nvPr/>
        </p:nvSpPr>
        <p:spPr>
          <a:xfrm>
            <a:off x="1185323" y="3415420"/>
            <a:ext cx="324349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8C3F816-7A47-49E5-C3B4-6EA856EE20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36112" y="1536125"/>
            <a:ext cx="1539223" cy="129427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65827BB-4CB8-C28A-EECA-8E9D256343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9963" y="3656699"/>
            <a:ext cx="1594670" cy="62087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08DA98A-E79B-58B9-E1E4-89AE37E9D8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11358" y="3373584"/>
            <a:ext cx="1645657" cy="97137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4E1C90E-24F0-A69A-8C1B-39851AC83E4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00976" y="4543818"/>
            <a:ext cx="1478616" cy="110700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2882C95-D407-0458-95A2-222DF92532A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11022" y="4526869"/>
            <a:ext cx="1538798" cy="1140903"/>
          </a:xfrm>
          <a:prstGeom prst="rect">
            <a:avLst/>
          </a:prstGeom>
        </p:spPr>
      </p:pic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DD1641A-C8DD-6FFC-BA29-20F395B181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9922882"/>
              </p:ext>
            </p:extLst>
          </p:nvPr>
        </p:nvGraphicFramePr>
        <p:xfrm>
          <a:off x="2759075" y="4605338"/>
          <a:ext cx="922338" cy="1135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085935" imgH="2560047" progId="Prism10.Document">
                  <p:embed/>
                </p:oleObj>
              </mc:Choice>
              <mc:Fallback>
                <p:oleObj name="Prism 10" r:id="rId9" imgW="2085935" imgH="2560047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DD1641A-C8DD-6FFC-BA29-20F395B181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759075" y="4605338"/>
                        <a:ext cx="922338" cy="1135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501DEF2-CD84-6C21-C031-E1E0343AB5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479247"/>
              </p:ext>
            </p:extLst>
          </p:nvPr>
        </p:nvGraphicFramePr>
        <p:xfrm>
          <a:off x="5127625" y="4641850"/>
          <a:ext cx="939800" cy="1135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127330" imgH="2560047" progId="Prism10.Document">
                  <p:embed/>
                </p:oleObj>
              </mc:Choice>
              <mc:Fallback>
                <p:oleObj name="Prism 10" r:id="rId11" imgW="2127330" imgH="2560047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501DEF2-CD84-6C21-C031-E1E0343AB5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127625" y="4641850"/>
                        <a:ext cx="939800" cy="1135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731253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18;p1">
            <a:extLst>
              <a:ext uri="{FF2B5EF4-FFF2-40B4-BE49-F238E27FC236}">
                <a16:creationId xmlns:a16="http://schemas.microsoft.com/office/drawing/2014/main" id="{2E47B640-00C0-DA43-9729-E51993B946DB}"/>
              </a:ext>
            </a:extLst>
          </p:cNvPr>
          <p:cNvSpPr txBox="1"/>
          <p:nvPr/>
        </p:nvSpPr>
        <p:spPr>
          <a:xfrm>
            <a:off x="4566379" y="-40390"/>
            <a:ext cx="2504475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2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" name="Google Shape;91;p1">
            <a:extLst>
              <a:ext uri="{FF2B5EF4-FFF2-40B4-BE49-F238E27FC236}">
                <a16:creationId xmlns:a16="http://schemas.microsoft.com/office/drawing/2014/main" id="{7D1E10CE-0792-754D-AA11-43242EB93C17}"/>
              </a:ext>
            </a:extLst>
          </p:cNvPr>
          <p:cNvSpPr txBox="1"/>
          <p:nvPr/>
        </p:nvSpPr>
        <p:spPr>
          <a:xfrm>
            <a:off x="769515" y="1316204"/>
            <a:ext cx="324349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" name="Google Shape;143;p3">
            <a:extLst>
              <a:ext uri="{FF2B5EF4-FFF2-40B4-BE49-F238E27FC236}">
                <a16:creationId xmlns:a16="http://schemas.microsoft.com/office/drawing/2014/main" id="{ED6E3338-5552-6C31-7A97-33DFA91C269E}"/>
              </a:ext>
            </a:extLst>
          </p:cNvPr>
          <p:cNvSpPr txBox="1"/>
          <p:nvPr/>
        </p:nvSpPr>
        <p:spPr>
          <a:xfrm>
            <a:off x="3613784" y="1310050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6" name="Google Shape;143;p3">
            <a:extLst>
              <a:ext uri="{FF2B5EF4-FFF2-40B4-BE49-F238E27FC236}">
                <a16:creationId xmlns:a16="http://schemas.microsoft.com/office/drawing/2014/main" id="{4D99BF2C-5B8A-A556-EB06-7C04F39FA91E}"/>
              </a:ext>
            </a:extLst>
          </p:cNvPr>
          <p:cNvSpPr txBox="1"/>
          <p:nvPr/>
        </p:nvSpPr>
        <p:spPr>
          <a:xfrm>
            <a:off x="787271" y="3251890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" name="Google Shape;143;p3">
            <a:extLst>
              <a:ext uri="{FF2B5EF4-FFF2-40B4-BE49-F238E27FC236}">
                <a16:creationId xmlns:a16="http://schemas.microsoft.com/office/drawing/2014/main" id="{10E65A14-6C50-150D-4D01-585D9DBBC739}"/>
              </a:ext>
            </a:extLst>
          </p:cNvPr>
          <p:cNvSpPr txBox="1"/>
          <p:nvPr/>
        </p:nvSpPr>
        <p:spPr>
          <a:xfrm>
            <a:off x="3613783" y="3251890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Google Shape;143;p3">
            <a:extLst>
              <a:ext uri="{FF2B5EF4-FFF2-40B4-BE49-F238E27FC236}">
                <a16:creationId xmlns:a16="http://schemas.microsoft.com/office/drawing/2014/main" id="{3F9F24FD-EC4B-1280-6845-198FD6713D0C}"/>
              </a:ext>
            </a:extLst>
          </p:cNvPr>
          <p:cNvSpPr txBox="1"/>
          <p:nvPr/>
        </p:nvSpPr>
        <p:spPr>
          <a:xfrm>
            <a:off x="787271" y="4923301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6DA976A-785D-FA2C-A3FF-1101437829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6525" y="3448185"/>
            <a:ext cx="1368649" cy="1200569"/>
          </a:xfrm>
          <a:prstGeom prst="rect">
            <a:avLst/>
          </a:prstGeom>
        </p:spPr>
      </p:pic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FE6882F0-64F3-F0FF-638C-6A0112B95F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6353777"/>
              </p:ext>
            </p:extLst>
          </p:nvPr>
        </p:nvGraphicFramePr>
        <p:xfrm>
          <a:off x="921062" y="1485239"/>
          <a:ext cx="2743200" cy="1736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5217537" imgH="2966804" progId="Prism9.Document">
                  <p:embed/>
                </p:oleObj>
              </mc:Choice>
              <mc:Fallback>
                <p:oleObj name="Prism 9" r:id="rId4" imgW="5217537" imgH="2966804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FE6882F0-64F3-F0FF-638C-6A0112B95F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21062" y="1485239"/>
                        <a:ext cx="2743200" cy="1736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6EF3ED6F-6B72-AD4D-AA45-80D455CFF6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0551067"/>
              </p:ext>
            </p:extLst>
          </p:nvPr>
        </p:nvGraphicFramePr>
        <p:xfrm>
          <a:off x="3709982" y="1483127"/>
          <a:ext cx="2743200" cy="17373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5185501" imgH="2968603" progId="Prism9.Document">
                  <p:embed/>
                </p:oleObj>
              </mc:Choice>
              <mc:Fallback>
                <p:oleObj name="Prism 9" r:id="rId6" imgW="5185501" imgH="2968603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6EF3ED6F-6B72-AD4D-AA45-80D455CFF6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709982" y="1483127"/>
                        <a:ext cx="2743200" cy="17373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Google Shape;123;p3">
            <a:extLst>
              <a:ext uri="{FF2B5EF4-FFF2-40B4-BE49-F238E27FC236}">
                <a16:creationId xmlns:a16="http://schemas.microsoft.com/office/drawing/2014/main" id="{E2646627-0532-25E2-BEB6-0CC5308D15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3071787"/>
              </p:ext>
            </p:extLst>
          </p:nvPr>
        </p:nvGraphicFramePr>
        <p:xfrm>
          <a:off x="4024313" y="3228975"/>
          <a:ext cx="1654175" cy="1719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921029" imgH="2953125" progId="Prism10.Document">
                  <p:embed/>
                </p:oleObj>
              </mc:Choice>
              <mc:Fallback>
                <p:oleObj name="Prism 10" r:id="rId8" imgW="2921029" imgH="2953125" progId="Prism10.Document">
                  <p:embed/>
                  <p:pic>
                    <p:nvPicPr>
                      <p:cNvPr id="14" name="Google Shape;123;p3">
                        <a:extLst>
                          <a:ext uri="{FF2B5EF4-FFF2-40B4-BE49-F238E27FC236}">
                            <a16:creationId xmlns:a16="http://schemas.microsoft.com/office/drawing/2014/main" id="{E2646627-0532-25E2-BEB6-0CC5308D15E5}"/>
                          </a:ext>
                        </a:extLst>
                      </p:cNvPr>
                      <p:cNvPicPr preferRelativeResize="0"/>
                      <p:nvPr/>
                    </p:nvPicPr>
                    <p:blipFill rotWithShape="1">
                      <a:blip r:embed="rId9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4024313" y="3228975"/>
                        <a:ext cx="1654175" cy="17192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8DB6CF2-6E3D-E55F-4D14-38CA22FE76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9476706"/>
              </p:ext>
            </p:extLst>
          </p:nvPr>
        </p:nvGraphicFramePr>
        <p:xfrm>
          <a:off x="4655760" y="4886008"/>
          <a:ext cx="1706562" cy="1452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541230" imgH="3018638" progId="Prism10.Document">
                  <p:embed/>
                </p:oleObj>
              </mc:Choice>
              <mc:Fallback>
                <p:oleObj name="Prism 10" r:id="rId10" imgW="3541230" imgH="3018638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8DB6CF2-6E3D-E55F-4D14-38CA22FE76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655760" y="4886008"/>
                        <a:ext cx="1706562" cy="1452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6" name="Picture 45">
            <a:extLst>
              <a:ext uri="{FF2B5EF4-FFF2-40B4-BE49-F238E27FC236}">
                <a16:creationId xmlns:a16="http://schemas.microsoft.com/office/drawing/2014/main" id="{A0F2F09C-C0E9-2415-66EE-FEE8225E1CE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23847" y="5032228"/>
            <a:ext cx="3855755" cy="11723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33196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54A61834-FF9B-767E-16BC-CB800FD84D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5594877"/>
              </p:ext>
            </p:extLst>
          </p:nvPr>
        </p:nvGraphicFramePr>
        <p:xfrm>
          <a:off x="360028" y="6283256"/>
          <a:ext cx="2526714" cy="1282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5603048" imgH="2966804" progId="Prism10.Document">
                  <p:embed/>
                </p:oleObj>
              </mc:Choice>
              <mc:Fallback>
                <p:oleObj name="Prism 10" r:id="rId4" imgW="5603048" imgH="2966804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54A61834-FF9B-767E-16BC-CB800FD84D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0028" y="6283256"/>
                        <a:ext cx="2526714" cy="1282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DB342948-225C-C919-F012-7CC4179F87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5315831"/>
              </p:ext>
            </p:extLst>
          </p:nvPr>
        </p:nvGraphicFramePr>
        <p:xfrm>
          <a:off x="3085333" y="6308637"/>
          <a:ext cx="2383560" cy="12727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5292048" imgH="2966804" progId="Prism10.Document">
                  <p:embed/>
                </p:oleObj>
              </mc:Choice>
              <mc:Fallback>
                <p:oleObj name="Prism 10" r:id="rId6" imgW="5292048" imgH="2966804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DB342948-225C-C919-F012-7CC4179F87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085333" y="6308637"/>
                        <a:ext cx="2383560" cy="12727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Google Shape;143;p3">
            <a:extLst>
              <a:ext uri="{FF2B5EF4-FFF2-40B4-BE49-F238E27FC236}">
                <a16:creationId xmlns:a16="http://schemas.microsoft.com/office/drawing/2014/main" id="{8CF43914-9E55-A249-B114-0DCB10BC61E6}"/>
              </a:ext>
            </a:extLst>
          </p:cNvPr>
          <p:cNvSpPr txBox="1"/>
          <p:nvPr/>
        </p:nvSpPr>
        <p:spPr>
          <a:xfrm>
            <a:off x="15469" y="3792224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" name="Google Shape;125;p2">
            <a:extLst>
              <a:ext uri="{FF2B5EF4-FFF2-40B4-BE49-F238E27FC236}">
                <a16:creationId xmlns:a16="http://schemas.microsoft.com/office/drawing/2014/main" id="{595D95D5-E62F-2341-82BD-C629058643F6}"/>
              </a:ext>
            </a:extLst>
          </p:cNvPr>
          <p:cNvSpPr txBox="1"/>
          <p:nvPr/>
        </p:nvSpPr>
        <p:spPr>
          <a:xfrm>
            <a:off x="4629873" y="0"/>
            <a:ext cx="2228127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3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8" name="Google Shape;143;p3">
            <a:extLst>
              <a:ext uri="{FF2B5EF4-FFF2-40B4-BE49-F238E27FC236}">
                <a16:creationId xmlns:a16="http://schemas.microsoft.com/office/drawing/2014/main" id="{28E4AB3B-1983-5A11-AF9B-BE6F3A5CCF08}"/>
              </a:ext>
            </a:extLst>
          </p:cNvPr>
          <p:cNvSpPr txBox="1"/>
          <p:nvPr/>
        </p:nvSpPr>
        <p:spPr>
          <a:xfrm>
            <a:off x="2356119" y="3701079"/>
            <a:ext cx="372830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" name="Google Shape;143;p3">
            <a:extLst>
              <a:ext uri="{FF2B5EF4-FFF2-40B4-BE49-F238E27FC236}">
                <a16:creationId xmlns:a16="http://schemas.microsoft.com/office/drawing/2014/main" id="{26021577-B265-58D5-7438-365B87876AF9}"/>
              </a:ext>
            </a:extLst>
          </p:cNvPr>
          <p:cNvSpPr txBox="1"/>
          <p:nvPr/>
        </p:nvSpPr>
        <p:spPr>
          <a:xfrm>
            <a:off x="2368913" y="5053545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Google Shape;143;p3">
            <a:extLst>
              <a:ext uri="{FF2B5EF4-FFF2-40B4-BE49-F238E27FC236}">
                <a16:creationId xmlns:a16="http://schemas.microsoft.com/office/drawing/2014/main" id="{7510C961-E30E-72EF-03B1-063E5BE0246D}"/>
              </a:ext>
            </a:extLst>
          </p:cNvPr>
          <p:cNvSpPr txBox="1"/>
          <p:nvPr/>
        </p:nvSpPr>
        <p:spPr>
          <a:xfrm>
            <a:off x="50763" y="6172395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F58AEF9-DB0D-E7F5-EFDF-D9786E22109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08444" y="5154046"/>
            <a:ext cx="2805443" cy="114956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083B46A-CE54-E55D-30D5-AB6FD1896CD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64218" y="3884905"/>
            <a:ext cx="2774876" cy="11361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99D8FAB-A9D1-15CE-4DDA-B782FA75AD4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4059" y="3952088"/>
            <a:ext cx="2166044" cy="1312412"/>
          </a:xfrm>
          <a:prstGeom prst="rect">
            <a:avLst/>
          </a:prstGeom>
        </p:spPr>
      </p:pic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5B41EB5B-3D5B-406A-7561-86E514C48F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6565531"/>
              </p:ext>
            </p:extLst>
          </p:nvPr>
        </p:nvGraphicFramePr>
        <p:xfrm>
          <a:off x="5239094" y="3852371"/>
          <a:ext cx="1481137" cy="1347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620827" imgH="2384746" progId="Prism10.Document">
                  <p:embed/>
                </p:oleObj>
              </mc:Choice>
              <mc:Fallback>
                <p:oleObj name="Prism 10" r:id="rId11" imgW="2620827" imgH="2384746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5B41EB5B-3D5B-406A-7561-86E514C48F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239094" y="3852371"/>
                        <a:ext cx="1481137" cy="1347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C4E0B28B-3808-FAE4-B9E5-6586138E6A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5859568"/>
              </p:ext>
            </p:extLst>
          </p:nvPr>
        </p:nvGraphicFramePr>
        <p:xfrm>
          <a:off x="5236422" y="5104358"/>
          <a:ext cx="1458913" cy="1439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2712256" imgH="2680274" progId="Prism10.Document">
                  <p:embed/>
                </p:oleObj>
              </mc:Choice>
              <mc:Fallback>
                <p:oleObj name="Prism 10" r:id="rId13" imgW="2712256" imgH="2680274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C4E0B28B-3808-FAE4-B9E5-6586138E6A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236422" y="5104358"/>
                        <a:ext cx="1458913" cy="1439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Google Shape;143;p3">
            <a:extLst>
              <a:ext uri="{FF2B5EF4-FFF2-40B4-BE49-F238E27FC236}">
                <a16:creationId xmlns:a16="http://schemas.microsoft.com/office/drawing/2014/main" id="{38D57DD9-A15D-ECE5-42DD-57AB5C6E9D40}"/>
              </a:ext>
            </a:extLst>
          </p:cNvPr>
          <p:cNvSpPr txBox="1"/>
          <p:nvPr/>
        </p:nvSpPr>
        <p:spPr>
          <a:xfrm>
            <a:off x="50763" y="1207693"/>
            <a:ext cx="306594" cy="2392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1" tIns="42184" rIns="84391" bIns="42184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1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00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" name="Google Shape;143;p3">
            <a:extLst>
              <a:ext uri="{FF2B5EF4-FFF2-40B4-BE49-F238E27FC236}">
                <a16:creationId xmlns:a16="http://schemas.microsoft.com/office/drawing/2014/main" id="{0DA2E6E6-2481-87B9-90D6-B0736F7DFD1C}"/>
              </a:ext>
            </a:extLst>
          </p:cNvPr>
          <p:cNvSpPr txBox="1"/>
          <p:nvPr/>
        </p:nvSpPr>
        <p:spPr>
          <a:xfrm>
            <a:off x="2342255" y="1244777"/>
            <a:ext cx="306594" cy="2392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1" tIns="42184" rIns="84391" bIns="42184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1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00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8E9A746-C04B-171E-BD82-FCABE6BB49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3290416"/>
              </p:ext>
            </p:extLst>
          </p:nvPr>
        </p:nvGraphicFramePr>
        <p:xfrm>
          <a:off x="5253038" y="1193800"/>
          <a:ext cx="1481137" cy="1347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2620827" imgH="2384746" progId="Prism10.Document">
                  <p:embed/>
                </p:oleObj>
              </mc:Choice>
              <mc:Fallback>
                <p:oleObj name="Prism 10" r:id="rId15" imgW="2620827" imgH="2384746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8E9A746-C04B-171E-BD82-FCABE6BB49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253038" y="1193800"/>
                        <a:ext cx="1481137" cy="1347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Google Shape;143;p3">
            <a:extLst>
              <a:ext uri="{FF2B5EF4-FFF2-40B4-BE49-F238E27FC236}">
                <a16:creationId xmlns:a16="http://schemas.microsoft.com/office/drawing/2014/main" id="{AE8E4A15-2A64-0C7C-F5C4-85A53128408B}"/>
              </a:ext>
            </a:extLst>
          </p:cNvPr>
          <p:cNvSpPr txBox="1"/>
          <p:nvPr/>
        </p:nvSpPr>
        <p:spPr>
          <a:xfrm>
            <a:off x="2346174" y="2443617"/>
            <a:ext cx="306594" cy="2392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1" tIns="42184" rIns="84391" bIns="42184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1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sz="100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4D9A36C-B10E-164D-C77A-736A3271EC8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476892" y="2549804"/>
            <a:ext cx="2774876" cy="1137781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83A671E6-538E-07CB-2076-4E1508D23D6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444457" y="1311182"/>
            <a:ext cx="2820764" cy="1153380"/>
          </a:xfrm>
          <a:prstGeom prst="rect">
            <a:avLst/>
          </a:prstGeom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2F6AB9B-5F25-2A5D-EF58-2E02F2C7CE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7134637"/>
              </p:ext>
            </p:extLst>
          </p:nvPr>
        </p:nvGraphicFramePr>
        <p:xfrm>
          <a:off x="5272088" y="2418652"/>
          <a:ext cx="1417637" cy="1439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2636305" imgH="2680274" progId="Prism10.Document">
                  <p:embed/>
                </p:oleObj>
              </mc:Choice>
              <mc:Fallback>
                <p:oleObj name="Prism 10" r:id="rId19" imgW="2636305" imgH="2680274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2F6AB9B-5F25-2A5D-EF58-2E02F2C7CE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272088" y="2418652"/>
                        <a:ext cx="1417637" cy="1439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0" name="Picture 19">
            <a:extLst>
              <a:ext uri="{FF2B5EF4-FFF2-40B4-BE49-F238E27FC236}">
                <a16:creationId xmlns:a16="http://schemas.microsoft.com/office/drawing/2014/main" id="{5969CEE7-C922-BC53-AA7A-883C4FAF2CD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66061" y="1297951"/>
            <a:ext cx="2165991" cy="1271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4952707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A34BCB61-4981-8960-35EE-7BD95C67C5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2700695"/>
              </p:ext>
            </p:extLst>
          </p:nvPr>
        </p:nvGraphicFramePr>
        <p:xfrm>
          <a:off x="475686" y="6563467"/>
          <a:ext cx="2447605" cy="12727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5459787" imgH="2966804" progId="Prism10.Document">
                  <p:embed/>
                </p:oleObj>
              </mc:Choice>
              <mc:Fallback>
                <p:oleObj name="Prism 10" r:id="rId4" imgW="5459787" imgH="2966804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A34BCB61-4981-8960-35EE-7BD95C67C5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5686" y="6563467"/>
                        <a:ext cx="2447605" cy="12727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CAA7F340-42B2-6AE0-5FB7-0AA4918AF1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4674180"/>
              </p:ext>
            </p:extLst>
          </p:nvPr>
        </p:nvGraphicFramePr>
        <p:xfrm>
          <a:off x="3295765" y="6584077"/>
          <a:ext cx="2447605" cy="12727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5386716" imgH="2966804" progId="Prism10.Document">
                  <p:embed/>
                </p:oleObj>
              </mc:Choice>
              <mc:Fallback>
                <p:oleObj name="Prism 10" r:id="rId6" imgW="5386716" imgH="2966804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CAA7F340-42B2-6AE0-5FB7-0AA4918AF1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295765" y="6584077"/>
                        <a:ext cx="2447605" cy="12727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Google Shape;125;p2">
            <a:extLst>
              <a:ext uri="{FF2B5EF4-FFF2-40B4-BE49-F238E27FC236}">
                <a16:creationId xmlns:a16="http://schemas.microsoft.com/office/drawing/2014/main" id="{595D95D5-E62F-2341-82BD-C629058643F6}"/>
              </a:ext>
            </a:extLst>
          </p:cNvPr>
          <p:cNvSpPr txBox="1"/>
          <p:nvPr/>
        </p:nvSpPr>
        <p:spPr>
          <a:xfrm>
            <a:off x="4629873" y="0"/>
            <a:ext cx="2228127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4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2" name="Google Shape;143;p3">
            <a:extLst>
              <a:ext uri="{FF2B5EF4-FFF2-40B4-BE49-F238E27FC236}">
                <a16:creationId xmlns:a16="http://schemas.microsoft.com/office/drawing/2014/main" id="{D36BB31D-2D26-F507-652B-9D039966D581}"/>
              </a:ext>
            </a:extLst>
          </p:cNvPr>
          <p:cNvSpPr txBox="1"/>
          <p:nvPr/>
        </p:nvSpPr>
        <p:spPr>
          <a:xfrm>
            <a:off x="141763" y="3982941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" name="Google Shape;143;p3">
            <a:extLst>
              <a:ext uri="{FF2B5EF4-FFF2-40B4-BE49-F238E27FC236}">
                <a16:creationId xmlns:a16="http://schemas.microsoft.com/office/drawing/2014/main" id="{E5AA7A2D-0EAE-96C5-5B7A-D6D5604EDF46}"/>
              </a:ext>
            </a:extLst>
          </p:cNvPr>
          <p:cNvSpPr txBox="1"/>
          <p:nvPr/>
        </p:nvSpPr>
        <p:spPr>
          <a:xfrm>
            <a:off x="2468837" y="3813752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" name="Google Shape;143;p3">
            <a:extLst>
              <a:ext uri="{FF2B5EF4-FFF2-40B4-BE49-F238E27FC236}">
                <a16:creationId xmlns:a16="http://schemas.microsoft.com/office/drawing/2014/main" id="{1EB4ACAB-B60C-AE77-3F2C-14C13D1CE370}"/>
              </a:ext>
            </a:extLst>
          </p:cNvPr>
          <p:cNvSpPr txBox="1"/>
          <p:nvPr/>
        </p:nvSpPr>
        <p:spPr>
          <a:xfrm>
            <a:off x="2459823" y="5177700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Google Shape;143;p3">
            <a:extLst>
              <a:ext uri="{FF2B5EF4-FFF2-40B4-BE49-F238E27FC236}">
                <a16:creationId xmlns:a16="http://schemas.microsoft.com/office/drawing/2014/main" id="{E9E776ED-8215-3D10-EF97-6EBEC535165C}"/>
              </a:ext>
            </a:extLst>
          </p:cNvPr>
          <p:cNvSpPr txBox="1"/>
          <p:nvPr/>
        </p:nvSpPr>
        <p:spPr>
          <a:xfrm>
            <a:off x="227455" y="6401493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DF4A4556-65FF-CB2F-7740-F5F717779D7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63759" y="5320118"/>
            <a:ext cx="2939265" cy="1206511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6AAC207B-DD94-5A23-66C4-CC9F48311D1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63259" y="3993338"/>
            <a:ext cx="2884731" cy="119539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C0CECD4-6AC6-B40B-DFF8-D379D7C72E0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2401" y="4152705"/>
            <a:ext cx="2190858" cy="1293215"/>
          </a:xfrm>
          <a:prstGeom prst="rect">
            <a:avLst/>
          </a:prstGeom>
        </p:spPr>
      </p:pic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A488B49F-94B4-263F-88EE-22F5349171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5740511"/>
              </p:ext>
            </p:extLst>
          </p:nvPr>
        </p:nvGraphicFramePr>
        <p:xfrm>
          <a:off x="5352133" y="3982941"/>
          <a:ext cx="1473200" cy="1347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901232" imgH="2657597" progId="Prism10.Document">
                  <p:embed/>
                </p:oleObj>
              </mc:Choice>
              <mc:Fallback>
                <p:oleObj name="Prism 10" r:id="rId11" imgW="2901232" imgH="2657597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A488B49F-94B4-263F-88EE-22F5349171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352133" y="3982941"/>
                        <a:ext cx="1473200" cy="1347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68F26A1C-CD29-5043-19D0-3E9026BF53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4413289"/>
              </p:ext>
            </p:extLst>
          </p:nvPr>
        </p:nvGraphicFramePr>
        <p:xfrm>
          <a:off x="5373687" y="5369322"/>
          <a:ext cx="1484313" cy="1417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070410" imgH="2939447" progId="Prism10.Document">
                  <p:embed/>
                </p:oleObj>
              </mc:Choice>
              <mc:Fallback>
                <p:oleObj name="Prism 10" r:id="rId13" imgW="3070410" imgH="2939447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68F26A1C-CD29-5043-19D0-3E9026BF53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373687" y="5369322"/>
                        <a:ext cx="1484313" cy="1417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Google Shape;143;p3">
            <a:extLst>
              <a:ext uri="{FF2B5EF4-FFF2-40B4-BE49-F238E27FC236}">
                <a16:creationId xmlns:a16="http://schemas.microsoft.com/office/drawing/2014/main" id="{B7385783-D12A-B85D-E132-3C6ED3B3447F}"/>
              </a:ext>
            </a:extLst>
          </p:cNvPr>
          <p:cNvSpPr txBox="1"/>
          <p:nvPr/>
        </p:nvSpPr>
        <p:spPr>
          <a:xfrm>
            <a:off x="2436588" y="1323985"/>
            <a:ext cx="306594" cy="2392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1" tIns="42184" rIns="84391" bIns="42184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1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00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" name="Google Shape;143;p3">
            <a:extLst>
              <a:ext uri="{FF2B5EF4-FFF2-40B4-BE49-F238E27FC236}">
                <a16:creationId xmlns:a16="http://schemas.microsoft.com/office/drawing/2014/main" id="{9C4FD6E7-F27F-8181-D5CE-80DEE3ADB98B}"/>
              </a:ext>
            </a:extLst>
          </p:cNvPr>
          <p:cNvSpPr txBox="1"/>
          <p:nvPr/>
        </p:nvSpPr>
        <p:spPr>
          <a:xfrm>
            <a:off x="145096" y="1310086"/>
            <a:ext cx="306594" cy="2392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1" tIns="42184" rIns="84391" bIns="42184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1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00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Google Shape;143;p3">
            <a:extLst>
              <a:ext uri="{FF2B5EF4-FFF2-40B4-BE49-F238E27FC236}">
                <a16:creationId xmlns:a16="http://schemas.microsoft.com/office/drawing/2014/main" id="{321F2EA4-BA93-1393-693A-945A080DFD00}"/>
              </a:ext>
            </a:extLst>
          </p:cNvPr>
          <p:cNvSpPr txBox="1"/>
          <p:nvPr/>
        </p:nvSpPr>
        <p:spPr>
          <a:xfrm>
            <a:off x="2468837" y="2572892"/>
            <a:ext cx="306594" cy="2392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1" tIns="42184" rIns="84391" bIns="42184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1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sz="1001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C30E3A6-1460-2F02-D72C-007610C659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5061602"/>
              </p:ext>
            </p:extLst>
          </p:nvPr>
        </p:nvGraphicFramePr>
        <p:xfrm>
          <a:off x="5333083" y="1370681"/>
          <a:ext cx="1473200" cy="1347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2901232" imgH="2657597" progId="Prism10.Document">
                  <p:embed/>
                </p:oleObj>
              </mc:Choice>
              <mc:Fallback>
                <p:oleObj name="Prism 10" r:id="rId15" imgW="2901232" imgH="2657597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C30E3A6-1460-2F02-D72C-007610C659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333083" y="1370681"/>
                        <a:ext cx="1473200" cy="1347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6B8C8CA-4AEC-002D-BFD1-FC16FDB2B1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8184272"/>
              </p:ext>
            </p:extLst>
          </p:nvPr>
        </p:nvGraphicFramePr>
        <p:xfrm>
          <a:off x="5356896" y="2618773"/>
          <a:ext cx="1468437" cy="131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036934" imgH="2723110" progId="Prism10.Document">
                  <p:embed/>
                </p:oleObj>
              </mc:Choice>
              <mc:Fallback>
                <p:oleObj name="Prism 10" r:id="rId17" imgW="3036934" imgH="2723110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6B8C8CA-4AEC-002D-BFD1-FC16FDB2B1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356896" y="2618773"/>
                        <a:ext cx="1468437" cy="131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7" name="Picture 66">
            <a:extLst>
              <a:ext uri="{FF2B5EF4-FFF2-40B4-BE49-F238E27FC236}">
                <a16:creationId xmlns:a16="http://schemas.microsoft.com/office/drawing/2014/main" id="{6E860B93-428D-11CD-5FAB-F6C0B8BA2E8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536269" y="1397276"/>
            <a:ext cx="2856186" cy="1183570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2A883C78-F696-5E02-3CEF-7C43449C2B64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541257" y="2646098"/>
            <a:ext cx="2782550" cy="1142182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DE2A454F-3995-56E1-25FA-A133EABD3482}"/>
              </a:ext>
            </a:extLst>
          </p:cNvPr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363457" y="1409701"/>
            <a:ext cx="2167128" cy="1271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1561120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125;p2">
            <a:extLst>
              <a:ext uri="{FF2B5EF4-FFF2-40B4-BE49-F238E27FC236}">
                <a16:creationId xmlns:a16="http://schemas.microsoft.com/office/drawing/2014/main" id="{595D95D5-E62F-2341-82BD-C629058643F6}"/>
              </a:ext>
            </a:extLst>
          </p:cNvPr>
          <p:cNvSpPr txBox="1"/>
          <p:nvPr/>
        </p:nvSpPr>
        <p:spPr>
          <a:xfrm>
            <a:off x="4592905" y="21793"/>
            <a:ext cx="2417734" cy="3006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800"/>
            </a:pPr>
            <a:r>
              <a:rPr lang="en-US" sz="14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5</a:t>
            </a:r>
            <a:endParaRPr sz="14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" name="Google Shape;143;p3">
            <a:extLst>
              <a:ext uri="{FF2B5EF4-FFF2-40B4-BE49-F238E27FC236}">
                <a16:creationId xmlns:a16="http://schemas.microsoft.com/office/drawing/2014/main" id="{EEEFA706-C14E-29CE-11E0-3BF9E16743E9}"/>
              </a:ext>
            </a:extLst>
          </p:cNvPr>
          <p:cNvSpPr txBox="1"/>
          <p:nvPr/>
        </p:nvSpPr>
        <p:spPr>
          <a:xfrm>
            <a:off x="405214" y="5105849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Google Shape;143;p3">
            <a:extLst>
              <a:ext uri="{FF2B5EF4-FFF2-40B4-BE49-F238E27FC236}">
                <a16:creationId xmlns:a16="http://schemas.microsoft.com/office/drawing/2014/main" id="{9F117B5D-D2DB-3B73-9809-16FC2BBD8DD6}"/>
              </a:ext>
            </a:extLst>
          </p:cNvPr>
          <p:cNvSpPr txBox="1"/>
          <p:nvPr/>
        </p:nvSpPr>
        <p:spPr>
          <a:xfrm>
            <a:off x="375284" y="822632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" name="Google Shape;143;p3">
            <a:extLst>
              <a:ext uri="{FF2B5EF4-FFF2-40B4-BE49-F238E27FC236}">
                <a16:creationId xmlns:a16="http://schemas.microsoft.com/office/drawing/2014/main" id="{C0BB567E-4C47-BA17-9576-1C0ACEA5C6B8}"/>
              </a:ext>
            </a:extLst>
          </p:cNvPr>
          <p:cNvSpPr txBox="1"/>
          <p:nvPr/>
        </p:nvSpPr>
        <p:spPr>
          <a:xfrm>
            <a:off x="2993240" y="764596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2A12B986-63B7-79F1-1A84-B6443B5522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5961" y="605294"/>
            <a:ext cx="1322555" cy="1370824"/>
          </a:xfrm>
          <a:prstGeom prst="rect">
            <a:avLst/>
          </a:prstGeom>
        </p:spPr>
      </p:pic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796CC80D-45B8-C761-4789-DEFB224C03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498512"/>
              </p:ext>
            </p:extLst>
          </p:nvPr>
        </p:nvGraphicFramePr>
        <p:xfrm>
          <a:off x="437570" y="2155567"/>
          <a:ext cx="2862263" cy="1589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4984287" imgH="2966804" progId="Prism9.Document">
                  <p:embed/>
                </p:oleObj>
              </mc:Choice>
              <mc:Fallback>
                <p:oleObj name="Prism 9" r:id="rId5" imgW="4984287" imgH="2966804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796CC80D-45B8-C761-4789-DEFB224C03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7570" y="2155567"/>
                        <a:ext cx="2862263" cy="1589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203B53DA-1A44-AEB8-C243-7E4435F7D1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0435125"/>
              </p:ext>
            </p:extLst>
          </p:nvPr>
        </p:nvGraphicFramePr>
        <p:xfrm>
          <a:off x="3364893" y="2152609"/>
          <a:ext cx="2845132" cy="15920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4963050" imgH="2968603" progId="Prism9.Document">
                  <p:embed/>
                </p:oleObj>
              </mc:Choice>
              <mc:Fallback>
                <p:oleObj name="Prism 9" r:id="rId7" imgW="4963050" imgH="2968603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203B53DA-1A44-AEB8-C243-7E4435F7D1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64893" y="2152609"/>
                        <a:ext cx="2845132" cy="15920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5671D3CD-437B-F9E9-6EE2-DE0014663B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2349167"/>
              </p:ext>
            </p:extLst>
          </p:nvPr>
        </p:nvGraphicFramePr>
        <p:xfrm>
          <a:off x="376446" y="3634953"/>
          <a:ext cx="2427207" cy="1590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4233062" imgH="2966804" progId="Prism9.Document">
                  <p:embed/>
                </p:oleObj>
              </mc:Choice>
              <mc:Fallback>
                <p:oleObj name="Prism 9" r:id="rId9" imgW="4233062" imgH="2966804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5671D3CD-437B-F9E9-6EE2-DE0014663B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6446" y="3634953"/>
                        <a:ext cx="2427207" cy="1590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Picture 13">
            <a:extLst>
              <a:ext uri="{FF2B5EF4-FFF2-40B4-BE49-F238E27FC236}">
                <a16:creationId xmlns:a16="http://schemas.microsoft.com/office/drawing/2014/main" id="{712ED87A-6E0E-4BFD-CDA8-7E19970B9B0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984499" y="4034093"/>
            <a:ext cx="3287239" cy="792156"/>
          </a:xfrm>
          <a:prstGeom prst="rect">
            <a:avLst/>
          </a:prstGeom>
        </p:spPr>
      </p:pic>
      <p:sp>
        <p:nvSpPr>
          <p:cNvPr id="21" name="Google Shape;143;p3">
            <a:extLst>
              <a:ext uri="{FF2B5EF4-FFF2-40B4-BE49-F238E27FC236}">
                <a16:creationId xmlns:a16="http://schemas.microsoft.com/office/drawing/2014/main" id="{58041CEF-4698-3BFC-0D51-30B59B18A816}"/>
              </a:ext>
            </a:extLst>
          </p:cNvPr>
          <p:cNvSpPr txBox="1"/>
          <p:nvPr/>
        </p:nvSpPr>
        <p:spPr>
          <a:xfrm>
            <a:off x="2993240" y="5126074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6" name="Google Shape;143;p3">
            <a:extLst>
              <a:ext uri="{FF2B5EF4-FFF2-40B4-BE49-F238E27FC236}">
                <a16:creationId xmlns:a16="http://schemas.microsoft.com/office/drawing/2014/main" id="{CE818360-92F0-E389-3CAB-54C0E840772F}"/>
              </a:ext>
            </a:extLst>
          </p:cNvPr>
          <p:cNvSpPr txBox="1"/>
          <p:nvPr/>
        </p:nvSpPr>
        <p:spPr>
          <a:xfrm>
            <a:off x="376297" y="2067380"/>
            <a:ext cx="306593" cy="2390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84392" tIns="42185" rIns="84392" bIns="4218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sz="1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000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7879CC5-50C4-A1EB-97C5-82CF573374B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21515" y="560935"/>
            <a:ext cx="1942077" cy="141518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120156E-BCD3-3CED-23C3-E571702DB62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251040" y="5305742"/>
            <a:ext cx="2052666" cy="121877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0623240-4A50-FF4C-BB52-1158EF4E86B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76259" y="5288356"/>
            <a:ext cx="2113861" cy="1248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979144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ppt/theme/themeOverride2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ppt/theme/themeOverride3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411</TotalTime>
  <Words>51</Words>
  <Application>Microsoft Office PowerPoint</Application>
  <PresentationFormat>Letter Paper (8.5x11 in)</PresentationFormat>
  <Paragraphs>40</Paragraphs>
  <Slides>5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10</vt:lpstr>
      <vt:lpstr>Prism 9</vt:lpstr>
      <vt:lpstr>GraphPad 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dey, Manoj Kumar</dc:creator>
  <cp:lastModifiedBy>Al-Odat, Omar Sami Faleh</cp:lastModifiedBy>
  <cp:revision>166</cp:revision>
  <cp:lastPrinted>2023-11-15T16:40:09Z</cp:lastPrinted>
  <dcterms:created xsi:type="dcterms:W3CDTF">2022-02-08T23:19:35Z</dcterms:created>
  <dcterms:modified xsi:type="dcterms:W3CDTF">2024-08-23T16:07:48Z</dcterms:modified>
</cp:coreProperties>
</file>